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7" r:id="rId2"/>
    <p:sldId id="258" r:id="rId3"/>
    <p:sldId id="261" r:id="rId4"/>
    <p:sldId id="262" r:id="rId5"/>
    <p:sldId id="265" r:id="rId6"/>
    <p:sldId id="267" r:id="rId7"/>
    <p:sldId id="270" r:id="rId8"/>
  </p:sldIdLst>
  <p:sldSz cx="12192000" cy="6858000"/>
  <p:notesSz cx="6858000" cy="9144000"/>
  <p:defaultTextStyle>
    <a:defPPr>
      <a:defRPr lang="en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67" y="7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B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9F5FB1-B1E5-44CD-9382-3232452FB261}" type="datetimeFigureOut">
              <a:rPr lang="en-BE" smtClean="0"/>
              <a:t>30/03/2026</a:t>
            </a:fld>
            <a:endParaRPr lang="en-B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B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99D1ED-A4E4-4596-B2A9-5605D9B3F1B2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6223595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4959E8-3B1A-44E0-89F3-C5C44581B3EB}" type="slidenum">
              <a:rPr lang="en-BE" smtClean="0"/>
              <a:t>3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7318996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B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04959E8-3B1A-44E0-89F3-C5C44581B3EB}" type="slidenum">
              <a:rPr lang="en-BE" smtClean="0"/>
              <a:t>6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1243077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3D69FE-22BE-B1F4-C703-DB3497781B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4C4D4C1-46C7-2E3A-6257-0717AF37B8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A54056-F3C4-DE25-9C87-041DCFECF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AC4F4-728E-4DCD-9B99-39BE227E6BA7}" type="datetimeFigureOut">
              <a:rPr lang="en-BE" smtClean="0"/>
              <a:t>30/03/2026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CBBDC4-7877-8B6D-32DE-6A8A68236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79614A-8376-AFCA-EF1D-9A9E2BCA15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B817-C88F-432D-8CAB-C44E7F478CA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945658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9A9C24-DE2A-9657-842C-62D34A1949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B3DFFD-FABB-B836-12FF-19CC82F61C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C4B7E8-F2D9-0DEA-638C-F2BD97FB0A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AC4F4-728E-4DCD-9B99-39BE227E6BA7}" type="datetimeFigureOut">
              <a:rPr lang="en-BE" smtClean="0"/>
              <a:t>30/03/2026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F67594-D08C-EAE9-7E28-306D5BFAAD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13D093-766B-AB34-ED0B-6FC2041F27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B817-C88F-432D-8CAB-C44E7F478CA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985665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8495F47-52A0-3912-E561-24526A7FF7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F141BE-168F-1753-B8EC-560FCE4A961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6107DB-0013-BA1C-3E2C-5D7EC7D1F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AC4F4-728E-4DCD-9B99-39BE227E6BA7}" type="datetimeFigureOut">
              <a:rPr lang="en-BE" smtClean="0"/>
              <a:t>30/03/2026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DE8157F-27E0-CF24-9EF1-69C021614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747170-CA0A-D623-5215-D8B183EDA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B817-C88F-432D-8CAB-C44E7F478CA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951818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5B65BB-C2FF-6FAD-AA9C-C9F77169E1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8CDC1F-E7E8-4183-0847-749E7E0C285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6102E0-BDDD-4ED9-5CB8-A25FFB52F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AC4F4-728E-4DCD-9B99-39BE227E6BA7}" type="datetimeFigureOut">
              <a:rPr lang="en-BE" smtClean="0"/>
              <a:t>30/03/2026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B890C8-D44E-942D-720B-56F1586BC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243788-0084-1780-8DBF-4294847BC1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B817-C88F-432D-8CAB-C44E7F478CA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3650416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F980D9-DFE2-D71D-BD62-BD12C6D2F0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DC0202-272A-DA16-A160-3F7B30E1CC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8DB654-E15B-A1D0-CDCD-4AB3160C7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AC4F4-728E-4DCD-9B99-39BE227E6BA7}" type="datetimeFigureOut">
              <a:rPr lang="en-BE" smtClean="0"/>
              <a:t>30/03/2026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FECEC0-5F61-98B3-BFF3-3B6194474A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0CC249-1E2C-3D7D-A773-9571D17E77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B817-C88F-432D-8CAB-C44E7F478CA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32924686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44E83F-479F-CBF5-C268-6EA5E37056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0ACEE7-704E-3163-DB8E-6558E8C67F8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371BC0-047F-1891-58D0-5E6791A013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8BCD0A-AE8C-D440-013C-976ABCF199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AC4F4-728E-4DCD-9B99-39BE227E6BA7}" type="datetimeFigureOut">
              <a:rPr lang="en-BE" smtClean="0"/>
              <a:t>30/03/2026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20A7FB-6D8B-BFA9-5162-A256F3C16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7FF9A1-1630-0218-2D4B-54C78C4C82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B817-C88F-432D-8CAB-C44E7F478CA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0321897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727AF2-DC5F-3DA3-17C4-8909AA1532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FF7955-20FA-B00D-6C1F-1B732C8D5C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7E7AF3-2481-4CCD-9B5F-6DCF85DD7A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D16473-D037-A05E-903E-37886DD51F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759C885-070D-A36E-24AC-F91A08EF274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B97A106-8295-C2AE-C381-909C9D460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AC4F4-728E-4DCD-9B99-39BE227E6BA7}" type="datetimeFigureOut">
              <a:rPr lang="en-BE" smtClean="0"/>
              <a:t>30/03/2026</a:t>
            </a:fld>
            <a:endParaRPr lang="en-B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7867B0E-21FC-E3CA-FC51-85F3866E28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B57CEE9-A9AE-53F7-EFD2-FDB4988FE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B817-C88F-432D-8CAB-C44E7F478CA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772190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D2CA38-0494-1A5B-8DD6-5BAB40682E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2026C4B-03FF-44DC-4FFF-BD6A62AB8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AC4F4-728E-4DCD-9B99-39BE227E6BA7}" type="datetimeFigureOut">
              <a:rPr lang="en-BE" smtClean="0"/>
              <a:t>30/03/2026</a:t>
            </a:fld>
            <a:endParaRPr lang="en-B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C6ACE7-8840-4FDA-BA5F-C0C65C4BD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833BF66-4588-2440-4271-1FA07DA0A5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B817-C88F-432D-8CAB-C44E7F478CA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2747518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1449C1F-F058-D0F5-9FDF-7F3B9286AD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AC4F4-728E-4DCD-9B99-39BE227E6BA7}" type="datetimeFigureOut">
              <a:rPr lang="en-BE" smtClean="0"/>
              <a:t>30/03/2026</a:t>
            </a:fld>
            <a:endParaRPr lang="en-B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6399F7-E0EF-4664-3F01-A3B3B4534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1E49695-00EF-A8BD-A837-600458F8B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B817-C88F-432D-8CAB-C44E7F478CA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5020887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36C7E1-2BC8-BC79-88AE-DD231401DA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625F1E-EC56-B5FF-38AF-D5F7E4E7B5B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B37908-D9DB-7F6A-ABF0-1DAC4BABC9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78ED9D-E8A8-DECE-1C99-78E513C77F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AC4F4-728E-4DCD-9B99-39BE227E6BA7}" type="datetimeFigureOut">
              <a:rPr lang="en-BE" smtClean="0"/>
              <a:t>30/03/2026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CCB140-D26C-BFA4-FC32-67F8D65BB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057E88-9CAB-55F6-F2DA-8A5D19D7E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B817-C88F-432D-8CAB-C44E7F478CA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262959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150026-6A61-B132-C173-9DD46D9AFF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B041EEC-295B-7457-DFC2-BBE7D327F6C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B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E83A6A-6660-09F9-81B6-848520BF50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6E8663-83B9-B6B1-33DE-B5D2BD42D1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DAC4F4-728E-4DCD-9B99-39BE227E6BA7}" type="datetimeFigureOut">
              <a:rPr lang="en-BE" smtClean="0"/>
              <a:t>30/03/2026</a:t>
            </a:fld>
            <a:endParaRPr lang="en-B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C346B7-644C-5DFB-3DAF-058E7064DF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F46AAE-CF94-8961-DDB3-F7DFFA1DB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71B817-C88F-432D-8CAB-C44E7F478CA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623338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A4B3442-4350-E19F-A242-E0FFF98E96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B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B2F81E-8DCF-B56C-97D5-D20F4A2968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F49B35-8899-49DC-51E5-EE11FF9607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1DAC4F4-728E-4DCD-9B99-39BE227E6BA7}" type="datetimeFigureOut">
              <a:rPr lang="en-BE" smtClean="0"/>
              <a:t>30/03/2026</a:t>
            </a:fld>
            <a:endParaRPr lang="en-B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7AAB65-C72F-237B-FFED-24F73CB3EA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B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1E381-D277-259D-DD0A-064F1B867D5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71B817-C88F-432D-8CAB-C44E7F478CA1}" type="slidenum">
              <a:rPr lang="en-BE" smtClean="0"/>
              <a:t>‹#›</a:t>
            </a:fld>
            <a:endParaRPr lang="en-BE"/>
          </a:p>
        </p:txBody>
      </p:sp>
    </p:spTree>
    <p:extLst>
      <p:ext uri="{BB962C8B-B14F-4D97-AF65-F5344CB8AC3E}">
        <p14:creationId xmlns:p14="http://schemas.microsoft.com/office/powerpoint/2010/main" val="1786244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JPEG"/><Relationship Id="rId4" Type="http://schemas.openxmlformats.org/officeDocument/2006/relationships/image" Target="../media/image10.JPE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F39E8366-BD34-896B-A7DA-1F07859B698C}"/>
              </a:ext>
            </a:extLst>
          </p:cNvPr>
          <p:cNvGrpSpPr/>
          <p:nvPr/>
        </p:nvGrpSpPr>
        <p:grpSpPr>
          <a:xfrm>
            <a:off x="136624" y="1716512"/>
            <a:ext cx="11657649" cy="2415923"/>
            <a:chOff x="180748" y="1546406"/>
            <a:chExt cx="11657649" cy="2415923"/>
          </a:xfrm>
        </p:grpSpPr>
        <p:pic>
          <p:nvPicPr>
            <p:cNvPr id="5" name="Picture 4" descr="A close-up of a dna sequence&#10;&#10;Description automatically generated">
              <a:extLst>
                <a:ext uri="{FF2B5EF4-FFF2-40B4-BE49-F238E27FC236}">
                  <a16:creationId xmlns:a16="http://schemas.microsoft.com/office/drawing/2014/main" id="{7272521D-9887-B09E-C512-FD3449DA54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726" t="8084" r="10715" b="56695"/>
            <a:stretch>
              <a:fillRect/>
            </a:stretch>
          </p:blipFill>
          <p:spPr>
            <a:xfrm>
              <a:off x="180748" y="1547009"/>
              <a:ext cx="6634717" cy="2415320"/>
            </a:xfrm>
            <a:prstGeom prst="rect">
              <a:avLst/>
            </a:prstGeom>
          </p:spPr>
        </p:pic>
        <p:pic>
          <p:nvPicPr>
            <p:cNvPr id="31" name="Picture 30" descr="A close-up of a dna sequence&#10;&#10;Description automatically generated">
              <a:extLst>
                <a:ext uri="{FF2B5EF4-FFF2-40B4-BE49-F238E27FC236}">
                  <a16:creationId xmlns:a16="http://schemas.microsoft.com/office/drawing/2014/main" id="{BCD49C09-50F5-01AC-F350-D4C74B45E2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379" t="57443" r="28972" b="7328"/>
            <a:stretch/>
          </p:blipFill>
          <p:spPr>
            <a:xfrm>
              <a:off x="6841369" y="1546406"/>
              <a:ext cx="4997028" cy="2415923"/>
            </a:xfrm>
            <a:prstGeom prst="rect">
              <a:avLst/>
            </a:prstGeom>
          </p:spPr>
        </p:pic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239E42CF-4E16-E438-133B-69DDB8A76103}"/>
                </a:ext>
              </a:extLst>
            </p:cNvPr>
            <p:cNvSpPr txBox="1"/>
            <p:nvPr/>
          </p:nvSpPr>
          <p:spPr>
            <a:xfrm>
              <a:off x="528595" y="3681101"/>
              <a:ext cx="1402761" cy="24621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rPV_pair-1 (226 bp)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E487CA0E-FF84-4788-C287-CB5B0CAA147B}"/>
                </a:ext>
              </a:extLst>
            </p:cNvPr>
            <p:cNvSpPr txBox="1"/>
            <p:nvPr/>
          </p:nvSpPr>
          <p:spPr>
            <a:xfrm>
              <a:off x="3827869" y="3681101"/>
              <a:ext cx="1402761" cy="24621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rPV_pair-3 (1033 bp)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6FAC85A9-DAC8-9E03-8573-ED9D824E2CCC}"/>
                </a:ext>
              </a:extLst>
            </p:cNvPr>
            <p:cNvSpPr txBox="1"/>
            <p:nvPr/>
          </p:nvSpPr>
          <p:spPr>
            <a:xfrm>
              <a:off x="5363473" y="3681101"/>
              <a:ext cx="1402761" cy="24621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rPV_pair-4 (615 bp)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36992388-3143-74D9-0C2F-2EFE74253391}"/>
                </a:ext>
              </a:extLst>
            </p:cNvPr>
            <p:cNvSpPr txBox="1"/>
            <p:nvPr/>
          </p:nvSpPr>
          <p:spPr>
            <a:xfrm>
              <a:off x="2063446" y="3681101"/>
              <a:ext cx="1402761" cy="24621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rPV_pair-2 (363 bp)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76A58219-7C5B-34AB-0DCF-50A66899EA24}"/>
                </a:ext>
              </a:extLst>
            </p:cNvPr>
            <p:cNvSpPr txBox="1"/>
            <p:nvPr/>
          </p:nvSpPr>
          <p:spPr>
            <a:xfrm>
              <a:off x="6932759" y="3681099"/>
              <a:ext cx="1481817" cy="24622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rPV_pair-5 (223 bp)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D4A517B3-7E4B-3851-D6AD-CF0B64B2DE79}"/>
                </a:ext>
              </a:extLst>
            </p:cNvPr>
            <p:cNvSpPr txBox="1"/>
            <p:nvPr/>
          </p:nvSpPr>
          <p:spPr>
            <a:xfrm>
              <a:off x="10077165" y="3681099"/>
              <a:ext cx="1468206" cy="24622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rPV_pair-7 (127 bp)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8FF2D9F-E737-340A-5103-EE40ADA16FA0}"/>
                </a:ext>
              </a:extLst>
            </p:cNvPr>
            <p:cNvSpPr txBox="1"/>
            <p:nvPr/>
          </p:nvSpPr>
          <p:spPr>
            <a:xfrm>
              <a:off x="8544490" y="3681101"/>
              <a:ext cx="1402761" cy="24621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rPV_pair-6 (132 bp)</a:t>
              </a:r>
            </a:p>
          </p:txBody>
        </p:sp>
      </p:grp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D951680F-65A0-9B1F-FC9D-57E94AE4CB42}"/>
              </a:ext>
            </a:extLst>
          </p:cNvPr>
          <p:cNvCxnSpPr>
            <a:cxnSpLocks/>
          </p:cNvCxnSpPr>
          <p:nvPr/>
        </p:nvCxnSpPr>
        <p:spPr>
          <a:xfrm flipV="1">
            <a:off x="477519" y="1470480"/>
            <a:ext cx="409523" cy="1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9D5FA4CD-0D23-F6F8-898F-87FF287BE5FD}"/>
              </a:ext>
            </a:extLst>
          </p:cNvPr>
          <p:cNvCxnSpPr>
            <a:cxnSpLocks/>
          </p:cNvCxnSpPr>
          <p:nvPr/>
        </p:nvCxnSpPr>
        <p:spPr>
          <a:xfrm flipV="1">
            <a:off x="986631" y="1470480"/>
            <a:ext cx="409523" cy="1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3FE7E5B8-F5D9-ACC7-A15B-56AEB54102E4}"/>
              </a:ext>
            </a:extLst>
          </p:cNvPr>
          <p:cNvSpPr txBox="1"/>
          <p:nvPr/>
        </p:nvSpPr>
        <p:spPr>
          <a:xfrm>
            <a:off x="360717" y="1178311"/>
            <a:ext cx="643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NA</a:t>
            </a:r>
            <a:endParaRPr lang="en-BE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FE1361B1-AF1D-7EF7-F982-7CF8AABB1D4B}"/>
              </a:ext>
            </a:extLst>
          </p:cNvPr>
          <p:cNvSpPr txBox="1"/>
          <p:nvPr/>
        </p:nvSpPr>
        <p:spPr>
          <a:xfrm>
            <a:off x="887042" y="1178311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NA</a:t>
            </a:r>
            <a:endParaRPr lang="en-BE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CABD89F-DFA7-D634-C0AF-AA48F0C40651}"/>
              </a:ext>
            </a:extLst>
          </p:cNvPr>
          <p:cNvSpPr txBox="1"/>
          <p:nvPr/>
        </p:nvSpPr>
        <p:spPr>
          <a:xfrm>
            <a:off x="379106" y="1433847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603CD7C4-279F-111F-89CF-0B3852A5568B}"/>
              </a:ext>
            </a:extLst>
          </p:cNvPr>
          <p:cNvSpPr txBox="1"/>
          <p:nvPr/>
        </p:nvSpPr>
        <p:spPr>
          <a:xfrm>
            <a:off x="643834" y="1432376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C732277-6914-EBA9-0C9B-37F1E5ECE5C6}"/>
              </a:ext>
            </a:extLst>
          </p:cNvPr>
          <p:cNvSpPr txBox="1"/>
          <p:nvPr/>
        </p:nvSpPr>
        <p:spPr>
          <a:xfrm>
            <a:off x="872375" y="1422374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6ADFCDE1-139D-2D8C-CD26-A530C962D847}"/>
              </a:ext>
            </a:extLst>
          </p:cNvPr>
          <p:cNvSpPr txBox="1"/>
          <p:nvPr/>
        </p:nvSpPr>
        <p:spPr>
          <a:xfrm>
            <a:off x="1145069" y="1437561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142427DD-C159-E66C-14A8-1CB4250B5A97}"/>
              </a:ext>
            </a:extLst>
          </p:cNvPr>
          <p:cNvSpPr txBox="1"/>
          <p:nvPr/>
        </p:nvSpPr>
        <p:spPr>
          <a:xfrm>
            <a:off x="1402765" y="1441813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+</a:t>
            </a:r>
            <a:endParaRPr lang="en-BE" sz="14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4244D632-85C7-13A4-0E23-4CE1616CD12E}"/>
              </a:ext>
            </a:extLst>
          </p:cNvPr>
          <p:cNvSpPr txBox="1"/>
          <p:nvPr/>
        </p:nvSpPr>
        <p:spPr>
          <a:xfrm>
            <a:off x="1651787" y="1422374"/>
            <a:ext cx="245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-</a:t>
            </a:r>
            <a:endParaRPr lang="en-BE" sz="1400" dirty="0"/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9A85E738-38AA-EBE1-533C-92050F55E3A6}"/>
              </a:ext>
            </a:extLst>
          </p:cNvPr>
          <p:cNvCxnSpPr>
            <a:cxnSpLocks/>
          </p:cNvCxnSpPr>
          <p:nvPr/>
        </p:nvCxnSpPr>
        <p:spPr>
          <a:xfrm flipV="1">
            <a:off x="2054491" y="1470480"/>
            <a:ext cx="409523" cy="1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AC9095F8-D773-5E97-A3AB-4B9A89AAD30E}"/>
              </a:ext>
            </a:extLst>
          </p:cNvPr>
          <p:cNvCxnSpPr>
            <a:cxnSpLocks/>
          </p:cNvCxnSpPr>
          <p:nvPr/>
        </p:nvCxnSpPr>
        <p:spPr>
          <a:xfrm flipV="1">
            <a:off x="2563603" y="1470480"/>
            <a:ext cx="409523" cy="1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7193F8E9-6F36-73CA-8013-A1BAB1118CE2}"/>
              </a:ext>
            </a:extLst>
          </p:cNvPr>
          <p:cNvSpPr txBox="1"/>
          <p:nvPr/>
        </p:nvSpPr>
        <p:spPr>
          <a:xfrm>
            <a:off x="1937689" y="1172638"/>
            <a:ext cx="643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NA</a:t>
            </a:r>
            <a:endParaRPr lang="en-BE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2BEBA762-F89F-21A1-653A-44FF88CB4A4D}"/>
              </a:ext>
            </a:extLst>
          </p:cNvPr>
          <p:cNvSpPr txBox="1"/>
          <p:nvPr/>
        </p:nvSpPr>
        <p:spPr>
          <a:xfrm>
            <a:off x="2464014" y="1172638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NA</a:t>
            </a:r>
            <a:endParaRPr lang="en-BE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E237C13-FBED-A579-15C3-557F84B3D04D}"/>
              </a:ext>
            </a:extLst>
          </p:cNvPr>
          <p:cNvSpPr txBox="1"/>
          <p:nvPr/>
        </p:nvSpPr>
        <p:spPr>
          <a:xfrm>
            <a:off x="1956078" y="1428174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4504473-707F-2FB7-06AB-1814FAC8F134}"/>
              </a:ext>
            </a:extLst>
          </p:cNvPr>
          <p:cNvSpPr txBox="1"/>
          <p:nvPr/>
        </p:nvSpPr>
        <p:spPr>
          <a:xfrm>
            <a:off x="2220806" y="1426703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B4BCF03-9BC8-4FEF-87C2-6F84A5A2B125}"/>
              </a:ext>
            </a:extLst>
          </p:cNvPr>
          <p:cNvSpPr txBox="1"/>
          <p:nvPr/>
        </p:nvSpPr>
        <p:spPr>
          <a:xfrm>
            <a:off x="2449347" y="1416701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9947BCDC-BB09-8B56-14D5-A3E0DD6336F2}"/>
              </a:ext>
            </a:extLst>
          </p:cNvPr>
          <p:cNvSpPr txBox="1"/>
          <p:nvPr/>
        </p:nvSpPr>
        <p:spPr>
          <a:xfrm>
            <a:off x="2722041" y="1431888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27A5160-76B2-B460-019E-154D727EE087}"/>
              </a:ext>
            </a:extLst>
          </p:cNvPr>
          <p:cNvSpPr txBox="1"/>
          <p:nvPr/>
        </p:nvSpPr>
        <p:spPr>
          <a:xfrm>
            <a:off x="2979737" y="1436140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+</a:t>
            </a:r>
            <a:endParaRPr lang="en-BE" sz="1400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CF8570C-4BE1-2CE9-4D22-DA3DA71BA3F1}"/>
              </a:ext>
            </a:extLst>
          </p:cNvPr>
          <p:cNvSpPr txBox="1"/>
          <p:nvPr/>
        </p:nvSpPr>
        <p:spPr>
          <a:xfrm>
            <a:off x="3228759" y="1416701"/>
            <a:ext cx="245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-</a:t>
            </a:r>
            <a:endParaRPr lang="en-BE" sz="1400" dirty="0"/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E402DA4C-862E-3C8B-44B2-3317CA576919}"/>
              </a:ext>
            </a:extLst>
          </p:cNvPr>
          <p:cNvCxnSpPr>
            <a:cxnSpLocks/>
          </p:cNvCxnSpPr>
          <p:nvPr/>
        </p:nvCxnSpPr>
        <p:spPr>
          <a:xfrm flipV="1">
            <a:off x="3809227" y="1470480"/>
            <a:ext cx="409523" cy="1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2DA7C260-8D76-C2AD-5F79-1067E6D51537}"/>
              </a:ext>
            </a:extLst>
          </p:cNvPr>
          <p:cNvCxnSpPr>
            <a:cxnSpLocks/>
          </p:cNvCxnSpPr>
          <p:nvPr/>
        </p:nvCxnSpPr>
        <p:spPr>
          <a:xfrm flipV="1">
            <a:off x="4318339" y="1470480"/>
            <a:ext cx="409523" cy="1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022E3C0E-CEEA-5EE4-4CB6-AEA399EE6B47}"/>
              </a:ext>
            </a:extLst>
          </p:cNvPr>
          <p:cNvSpPr txBox="1"/>
          <p:nvPr/>
        </p:nvSpPr>
        <p:spPr>
          <a:xfrm>
            <a:off x="3692425" y="1177503"/>
            <a:ext cx="643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NA</a:t>
            </a:r>
            <a:endParaRPr lang="en-BE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3CA5DDE8-AC18-863B-8C9D-F598DCBF254F}"/>
              </a:ext>
            </a:extLst>
          </p:cNvPr>
          <p:cNvSpPr txBox="1"/>
          <p:nvPr/>
        </p:nvSpPr>
        <p:spPr>
          <a:xfrm>
            <a:off x="4218750" y="1177503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NA</a:t>
            </a:r>
            <a:endParaRPr lang="en-BE" dirty="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D5B5EB53-1E00-9174-8F68-597B2AF0A037}"/>
              </a:ext>
            </a:extLst>
          </p:cNvPr>
          <p:cNvSpPr txBox="1"/>
          <p:nvPr/>
        </p:nvSpPr>
        <p:spPr>
          <a:xfrm>
            <a:off x="3710814" y="1433039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D88E1E3E-D1F9-4DDF-2B86-60780B87A363}"/>
              </a:ext>
            </a:extLst>
          </p:cNvPr>
          <p:cNvSpPr txBox="1"/>
          <p:nvPr/>
        </p:nvSpPr>
        <p:spPr>
          <a:xfrm>
            <a:off x="3975542" y="1431568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14A1085C-7356-B2F4-C24A-FB1308F62886}"/>
              </a:ext>
            </a:extLst>
          </p:cNvPr>
          <p:cNvSpPr txBox="1"/>
          <p:nvPr/>
        </p:nvSpPr>
        <p:spPr>
          <a:xfrm>
            <a:off x="4204083" y="1421566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4D77D1C0-D8BD-32BC-B445-B00A94DF625A}"/>
              </a:ext>
            </a:extLst>
          </p:cNvPr>
          <p:cNvSpPr txBox="1"/>
          <p:nvPr/>
        </p:nvSpPr>
        <p:spPr>
          <a:xfrm>
            <a:off x="4476777" y="1436753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AE971ECD-AAA7-7EF6-3E2A-07D09A2FCB1D}"/>
              </a:ext>
            </a:extLst>
          </p:cNvPr>
          <p:cNvSpPr txBox="1"/>
          <p:nvPr/>
        </p:nvSpPr>
        <p:spPr>
          <a:xfrm>
            <a:off x="4734473" y="1441005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+</a:t>
            </a:r>
            <a:endParaRPr lang="en-BE" sz="1400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56CA7D5F-B6FC-1C4C-4B95-442359588846}"/>
              </a:ext>
            </a:extLst>
          </p:cNvPr>
          <p:cNvSpPr txBox="1"/>
          <p:nvPr/>
        </p:nvSpPr>
        <p:spPr>
          <a:xfrm>
            <a:off x="4983495" y="1421566"/>
            <a:ext cx="245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-</a:t>
            </a:r>
            <a:endParaRPr lang="en-BE" sz="1400" dirty="0"/>
          </a:p>
        </p:txBody>
      </p: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7C33A68A-4104-6375-3703-2271FBC29E51}"/>
              </a:ext>
            </a:extLst>
          </p:cNvPr>
          <p:cNvCxnSpPr>
            <a:cxnSpLocks/>
          </p:cNvCxnSpPr>
          <p:nvPr/>
        </p:nvCxnSpPr>
        <p:spPr>
          <a:xfrm flipV="1">
            <a:off x="5368367" y="1470480"/>
            <a:ext cx="409523" cy="1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CB7A88BD-B48B-9C7C-CC5D-FACA34280BFE}"/>
              </a:ext>
            </a:extLst>
          </p:cNvPr>
          <p:cNvCxnSpPr>
            <a:cxnSpLocks/>
          </p:cNvCxnSpPr>
          <p:nvPr/>
        </p:nvCxnSpPr>
        <p:spPr>
          <a:xfrm flipV="1">
            <a:off x="5877479" y="1470480"/>
            <a:ext cx="409523" cy="1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E467AFB2-AC60-B389-5F14-266525E9700E}"/>
              </a:ext>
            </a:extLst>
          </p:cNvPr>
          <p:cNvSpPr txBox="1"/>
          <p:nvPr/>
        </p:nvSpPr>
        <p:spPr>
          <a:xfrm>
            <a:off x="5251565" y="1172638"/>
            <a:ext cx="643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NA</a:t>
            </a:r>
            <a:endParaRPr lang="en-BE" dirty="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8D8C93B7-CBC7-F19D-9064-9499793A809C}"/>
              </a:ext>
            </a:extLst>
          </p:cNvPr>
          <p:cNvSpPr txBox="1"/>
          <p:nvPr/>
        </p:nvSpPr>
        <p:spPr>
          <a:xfrm>
            <a:off x="5777890" y="1172638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NA</a:t>
            </a:r>
            <a:endParaRPr lang="en-BE" dirty="0"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44CD9ADE-52D7-AAB4-476E-59C2F9BF7DDF}"/>
              </a:ext>
            </a:extLst>
          </p:cNvPr>
          <p:cNvSpPr txBox="1"/>
          <p:nvPr/>
        </p:nvSpPr>
        <p:spPr>
          <a:xfrm>
            <a:off x="5269954" y="1428174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718EDFC4-99DF-E412-AA22-FE982323ADD2}"/>
              </a:ext>
            </a:extLst>
          </p:cNvPr>
          <p:cNvSpPr txBox="1"/>
          <p:nvPr/>
        </p:nvSpPr>
        <p:spPr>
          <a:xfrm>
            <a:off x="5534682" y="1426703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6C15475F-EA13-A3A2-F23F-200D8CD911CE}"/>
              </a:ext>
            </a:extLst>
          </p:cNvPr>
          <p:cNvSpPr txBox="1"/>
          <p:nvPr/>
        </p:nvSpPr>
        <p:spPr>
          <a:xfrm>
            <a:off x="5763223" y="1416701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A4F2468-5476-C0F4-A846-FAF27C69CA9E}"/>
              </a:ext>
            </a:extLst>
          </p:cNvPr>
          <p:cNvSpPr txBox="1"/>
          <p:nvPr/>
        </p:nvSpPr>
        <p:spPr>
          <a:xfrm>
            <a:off x="6035917" y="1431888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F3F3EDFB-1FB6-33F7-1DCB-CC8448939C51}"/>
              </a:ext>
            </a:extLst>
          </p:cNvPr>
          <p:cNvSpPr txBox="1"/>
          <p:nvPr/>
        </p:nvSpPr>
        <p:spPr>
          <a:xfrm>
            <a:off x="6293613" y="1436140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+</a:t>
            </a:r>
            <a:endParaRPr lang="en-BE" sz="1400" dirty="0"/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C6377D42-24C6-F41C-EB15-3F09B51950AA}"/>
              </a:ext>
            </a:extLst>
          </p:cNvPr>
          <p:cNvSpPr txBox="1"/>
          <p:nvPr/>
        </p:nvSpPr>
        <p:spPr>
          <a:xfrm>
            <a:off x="6542635" y="1416701"/>
            <a:ext cx="245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-</a:t>
            </a:r>
            <a:endParaRPr lang="en-BE" sz="1400" dirty="0"/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C2E1DC75-17B9-0AE1-2F93-8861E57A5D9A}"/>
              </a:ext>
            </a:extLst>
          </p:cNvPr>
          <p:cNvCxnSpPr>
            <a:cxnSpLocks/>
          </p:cNvCxnSpPr>
          <p:nvPr/>
        </p:nvCxnSpPr>
        <p:spPr>
          <a:xfrm flipV="1">
            <a:off x="6987048" y="1470480"/>
            <a:ext cx="409523" cy="1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AB7C8697-C407-C3EA-F951-2DB300DC366B}"/>
              </a:ext>
            </a:extLst>
          </p:cNvPr>
          <p:cNvCxnSpPr>
            <a:cxnSpLocks/>
          </p:cNvCxnSpPr>
          <p:nvPr/>
        </p:nvCxnSpPr>
        <p:spPr>
          <a:xfrm flipV="1">
            <a:off x="7496160" y="1470480"/>
            <a:ext cx="409523" cy="1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2" name="TextBox 101">
            <a:extLst>
              <a:ext uri="{FF2B5EF4-FFF2-40B4-BE49-F238E27FC236}">
                <a16:creationId xmlns:a16="http://schemas.microsoft.com/office/drawing/2014/main" id="{329DAD67-633F-1A0B-7205-47C4CDCEA4F2}"/>
              </a:ext>
            </a:extLst>
          </p:cNvPr>
          <p:cNvSpPr txBox="1"/>
          <p:nvPr/>
        </p:nvSpPr>
        <p:spPr>
          <a:xfrm>
            <a:off x="6870246" y="1177503"/>
            <a:ext cx="643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NA</a:t>
            </a:r>
            <a:endParaRPr lang="en-BE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33C637FC-926A-9A9B-4F5E-1A786DD8619F}"/>
              </a:ext>
            </a:extLst>
          </p:cNvPr>
          <p:cNvSpPr txBox="1"/>
          <p:nvPr/>
        </p:nvSpPr>
        <p:spPr>
          <a:xfrm>
            <a:off x="7396571" y="1177503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NA</a:t>
            </a:r>
            <a:endParaRPr lang="en-BE" dirty="0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833EC5C5-E830-A122-6576-01434099346F}"/>
              </a:ext>
            </a:extLst>
          </p:cNvPr>
          <p:cNvSpPr txBox="1"/>
          <p:nvPr/>
        </p:nvSpPr>
        <p:spPr>
          <a:xfrm>
            <a:off x="6888635" y="1433039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97E8EE7-2A3B-1328-D52F-28533E0F16BD}"/>
              </a:ext>
            </a:extLst>
          </p:cNvPr>
          <p:cNvSpPr txBox="1"/>
          <p:nvPr/>
        </p:nvSpPr>
        <p:spPr>
          <a:xfrm>
            <a:off x="7153363" y="1431568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E10EFC40-FC76-09B2-FA1E-19671DA863DA}"/>
              </a:ext>
            </a:extLst>
          </p:cNvPr>
          <p:cNvSpPr txBox="1"/>
          <p:nvPr/>
        </p:nvSpPr>
        <p:spPr>
          <a:xfrm>
            <a:off x="7381904" y="1421566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701DE0F-ED8B-193D-E82D-E634DFC18DAF}"/>
              </a:ext>
            </a:extLst>
          </p:cNvPr>
          <p:cNvSpPr txBox="1"/>
          <p:nvPr/>
        </p:nvSpPr>
        <p:spPr>
          <a:xfrm>
            <a:off x="7654598" y="1436753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C8039E12-FA6B-07F2-81F9-9378567C3DCD}"/>
              </a:ext>
            </a:extLst>
          </p:cNvPr>
          <p:cNvSpPr txBox="1"/>
          <p:nvPr/>
        </p:nvSpPr>
        <p:spPr>
          <a:xfrm>
            <a:off x="7912294" y="1441005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+</a:t>
            </a:r>
            <a:endParaRPr lang="en-BE" sz="1400" dirty="0"/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996202E3-C710-6606-1453-A49F3DDDB9BD}"/>
              </a:ext>
            </a:extLst>
          </p:cNvPr>
          <p:cNvSpPr txBox="1"/>
          <p:nvPr/>
        </p:nvSpPr>
        <p:spPr>
          <a:xfrm>
            <a:off x="8161316" y="1421566"/>
            <a:ext cx="245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-</a:t>
            </a:r>
            <a:endParaRPr lang="en-BE" sz="1400" dirty="0"/>
          </a:p>
        </p:txBody>
      </p: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C1C6E548-D2D0-72C6-4735-C6BD48B75FF8}"/>
              </a:ext>
            </a:extLst>
          </p:cNvPr>
          <p:cNvCxnSpPr>
            <a:cxnSpLocks/>
          </p:cNvCxnSpPr>
          <p:nvPr/>
        </p:nvCxnSpPr>
        <p:spPr>
          <a:xfrm flipV="1">
            <a:off x="8522365" y="1470480"/>
            <a:ext cx="409523" cy="1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>
            <a:extLst>
              <a:ext uri="{FF2B5EF4-FFF2-40B4-BE49-F238E27FC236}">
                <a16:creationId xmlns:a16="http://schemas.microsoft.com/office/drawing/2014/main" id="{2C3D9B34-C2E6-0CA5-B9FC-EFD2446460FF}"/>
              </a:ext>
            </a:extLst>
          </p:cNvPr>
          <p:cNvCxnSpPr>
            <a:cxnSpLocks/>
          </p:cNvCxnSpPr>
          <p:nvPr/>
        </p:nvCxnSpPr>
        <p:spPr>
          <a:xfrm flipV="1">
            <a:off x="9031477" y="1470480"/>
            <a:ext cx="409523" cy="1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2" name="TextBox 111">
            <a:extLst>
              <a:ext uri="{FF2B5EF4-FFF2-40B4-BE49-F238E27FC236}">
                <a16:creationId xmlns:a16="http://schemas.microsoft.com/office/drawing/2014/main" id="{44CB1C53-92ED-C893-6A10-71FF8A77B6B7}"/>
              </a:ext>
            </a:extLst>
          </p:cNvPr>
          <p:cNvSpPr txBox="1"/>
          <p:nvPr/>
        </p:nvSpPr>
        <p:spPr>
          <a:xfrm>
            <a:off x="8405563" y="1170345"/>
            <a:ext cx="643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NA</a:t>
            </a:r>
            <a:endParaRPr lang="en-BE" dirty="0"/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7BD0A897-C9F3-21A1-338D-76D2BB015745}"/>
              </a:ext>
            </a:extLst>
          </p:cNvPr>
          <p:cNvSpPr txBox="1"/>
          <p:nvPr/>
        </p:nvSpPr>
        <p:spPr>
          <a:xfrm>
            <a:off x="8931888" y="1170345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NA</a:t>
            </a:r>
            <a:endParaRPr lang="en-BE" dirty="0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073F0722-8925-29F2-377D-E32792C551C6}"/>
              </a:ext>
            </a:extLst>
          </p:cNvPr>
          <p:cNvSpPr txBox="1"/>
          <p:nvPr/>
        </p:nvSpPr>
        <p:spPr>
          <a:xfrm>
            <a:off x="8423952" y="1425881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60582BA4-80E0-C600-94F3-DB85145644FE}"/>
              </a:ext>
            </a:extLst>
          </p:cNvPr>
          <p:cNvSpPr txBox="1"/>
          <p:nvPr/>
        </p:nvSpPr>
        <p:spPr>
          <a:xfrm>
            <a:off x="8688680" y="1424410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49E8C52F-0817-58DD-C544-06EC1F71C520}"/>
              </a:ext>
            </a:extLst>
          </p:cNvPr>
          <p:cNvSpPr txBox="1"/>
          <p:nvPr/>
        </p:nvSpPr>
        <p:spPr>
          <a:xfrm>
            <a:off x="8917221" y="1414408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9512AAD3-6BE1-0492-AD79-BE7BA8DE3805}"/>
              </a:ext>
            </a:extLst>
          </p:cNvPr>
          <p:cNvSpPr txBox="1"/>
          <p:nvPr/>
        </p:nvSpPr>
        <p:spPr>
          <a:xfrm>
            <a:off x="9189915" y="1429595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EA6E0382-5C2A-07D7-C934-1BC135DAA6C6}"/>
              </a:ext>
            </a:extLst>
          </p:cNvPr>
          <p:cNvSpPr txBox="1"/>
          <p:nvPr/>
        </p:nvSpPr>
        <p:spPr>
          <a:xfrm>
            <a:off x="9447611" y="1433847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+</a:t>
            </a:r>
            <a:endParaRPr lang="en-BE" sz="1400" dirty="0"/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002FD15D-AF70-0E61-4CE6-30EBDB21BE4E}"/>
              </a:ext>
            </a:extLst>
          </p:cNvPr>
          <p:cNvSpPr txBox="1"/>
          <p:nvPr/>
        </p:nvSpPr>
        <p:spPr>
          <a:xfrm>
            <a:off x="9696633" y="1414408"/>
            <a:ext cx="245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-</a:t>
            </a:r>
            <a:endParaRPr lang="en-BE" sz="1400" dirty="0"/>
          </a:p>
        </p:txBody>
      </p: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1C137C93-C620-989B-81C7-033BFD75F549}"/>
              </a:ext>
            </a:extLst>
          </p:cNvPr>
          <p:cNvCxnSpPr>
            <a:cxnSpLocks/>
          </p:cNvCxnSpPr>
          <p:nvPr/>
        </p:nvCxnSpPr>
        <p:spPr>
          <a:xfrm flipV="1">
            <a:off x="10081399" y="1470480"/>
            <a:ext cx="409523" cy="1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A41FBEFD-58F4-5052-962A-14B0C8A89FCE}"/>
              </a:ext>
            </a:extLst>
          </p:cNvPr>
          <p:cNvCxnSpPr>
            <a:cxnSpLocks/>
          </p:cNvCxnSpPr>
          <p:nvPr/>
        </p:nvCxnSpPr>
        <p:spPr>
          <a:xfrm flipV="1">
            <a:off x="10590511" y="1470480"/>
            <a:ext cx="409523" cy="1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:a16="http://schemas.microsoft.com/office/drawing/2014/main" id="{D92BC65D-E269-D061-191B-D7FA15972F99}"/>
              </a:ext>
            </a:extLst>
          </p:cNvPr>
          <p:cNvSpPr txBox="1"/>
          <p:nvPr/>
        </p:nvSpPr>
        <p:spPr>
          <a:xfrm>
            <a:off x="9964597" y="1164672"/>
            <a:ext cx="643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NA</a:t>
            </a:r>
            <a:endParaRPr lang="en-BE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8A0D9045-CB22-E0F2-7C53-50FDEB316322}"/>
              </a:ext>
            </a:extLst>
          </p:cNvPr>
          <p:cNvSpPr txBox="1"/>
          <p:nvPr/>
        </p:nvSpPr>
        <p:spPr>
          <a:xfrm>
            <a:off x="10490922" y="1164672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NA</a:t>
            </a:r>
            <a:endParaRPr lang="en-BE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AB2CCDAE-93B3-BD73-7432-E03DC71827DB}"/>
              </a:ext>
            </a:extLst>
          </p:cNvPr>
          <p:cNvSpPr txBox="1"/>
          <p:nvPr/>
        </p:nvSpPr>
        <p:spPr>
          <a:xfrm>
            <a:off x="9982986" y="1420208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8BCA9081-8A25-49D4-20F1-3A7FE2A8E61E}"/>
              </a:ext>
            </a:extLst>
          </p:cNvPr>
          <p:cNvSpPr txBox="1"/>
          <p:nvPr/>
        </p:nvSpPr>
        <p:spPr>
          <a:xfrm>
            <a:off x="10247714" y="1418737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30A51FE9-59CA-D3D0-D58F-8FB27556F99B}"/>
              </a:ext>
            </a:extLst>
          </p:cNvPr>
          <p:cNvSpPr txBox="1"/>
          <p:nvPr/>
        </p:nvSpPr>
        <p:spPr>
          <a:xfrm>
            <a:off x="10476255" y="1408735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38E867AB-4EAD-7981-08F4-43B83126DB79}"/>
              </a:ext>
            </a:extLst>
          </p:cNvPr>
          <p:cNvSpPr txBox="1"/>
          <p:nvPr/>
        </p:nvSpPr>
        <p:spPr>
          <a:xfrm>
            <a:off x="10748949" y="1423922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062C249A-F3DA-237B-A18F-79C000FA5B77}"/>
              </a:ext>
            </a:extLst>
          </p:cNvPr>
          <p:cNvSpPr txBox="1"/>
          <p:nvPr/>
        </p:nvSpPr>
        <p:spPr>
          <a:xfrm>
            <a:off x="11006645" y="1428174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+</a:t>
            </a:r>
            <a:endParaRPr lang="en-BE" sz="1400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69530DB5-7252-539D-4A39-C1D886C690DF}"/>
              </a:ext>
            </a:extLst>
          </p:cNvPr>
          <p:cNvSpPr txBox="1"/>
          <p:nvPr/>
        </p:nvSpPr>
        <p:spPr>
          <a:xfrm>
            <a:off x="11255667" y="1408735"/>
            <a:ext cx="245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-</a:t>
            </a:r>
            <a:endParaRPr lang="en-BE" sz="1400" dirty="0"/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D97DB32A-2383-7AD2-1D11-E0BA907592B4}"/>
              </a:ext>
            </a:extLst>
          </p:cNvPr>
          <p:cNvSpPr txBox="1"/>
          <p:nvPr/>
        </p:nvSpPr>
        <p:spPr>
          <a:xfrm>
            <a:off x="202975" y="4739079"/>
            <a:ext cx="1181939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 A:</a:t>
            </a:r>
            <a:r>
              <a:rPr lang="en-US" dirty="0"/>
              <a:t> Amplicons produced with </a:t>
            </a:r>
            <a:r>
              <a:rPr lang="en-US" dirty="0" err="1"/>
              <a:t>CrPV</a:t>
            </a:r>
            <a:r>
              <a:rPr lang="en-US" dirty="0"/>
              <a:t>-specific primers from DNA or RNA extracts of virus-infected (V) or mock-infected (M) cells. +: positive control, -: non-template control. The </a:t>
            </a:r>
            <a:r>
              <a:rPr lang="en-US" dirty="0" err="1"/>
              <a:t>Thermo</a:t>
            </a:r>
            <a:r>
              <a:rPr lang="en-US" dirty="0"/>
              <a:t> Fisher Scientific 1 </a:t>
            </a:r>
            <a:r>
              <a:rPr lang="en-US" dirty="0" err="1"/>
              <a:t>Kb</a:t>
            </a:r>
            <a:r>
              <a:rPr lang="en-US" dirty="0"/>
              <a:t> Plus DNA ladder was used as a reference. </a:t>
            </a:r>
            <a:endParaRPr lang="en-BE" dirty="0"/>
          </a:p>
          <a:p>
            <a:endParaRPr lang="en-BE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BAC2AD4-65DB-AC1A-64FD-692C3A81F75F}"/>
              </a:ext>
            </a:extLst>
          </p:cNvPr>
          <p:cNvSpPr txBox="1"/>
          <p:nvPr/>
        </p:nvSpPr>
        <p:spPr>
          <a:xfrm>
            <a:off x="156597" y="623578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  <a:endParaRPr lang="en-BE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2FF1D71-F113-EDB9-643B-87593A9C70B4}"/>
              </a:ext>
            </a:extLst>
          </p:cNvPr>
          <p:cNvSpPr txBox="1"/>
          <p:nvPr/>
        </p:nvSpPr>
        <p:spPr>
          <a:xfrm>
            <a:off x="11753256" y="3225225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100 bp</a:t>
            </a:r>
            <a:endParaRPr lang="en-BE" sz="8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A908252-7343-A703-9078-13F5892EBF61}"/>
              </a:ext>
            </a:extLst>
          </p:cNvPr>
          <p:cNvSpPr txBox="1"/>
          <p:nvPr/>
        </p:nvSpPr>
        <p:spPr>
          <a:xfrm>
            <a:off x="11753256" y="3058784"/>
            <a:ext cx="4924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200</a:t>
            </a:r>
            <a:r>
              <a:rPr lang="en-GB" sz="1100" dirty="0"/>
              <a:t> </a:t>
            </a:r>
            <a:r>
              <a:rPr lang="en-GB" sz="800" dirty="0"/>
              <a:t>bp</a:t>
            </a:r>
            <a:endParaRPr lang="en-BE" sz="8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4564681-B868-A215-4BE1-0644FC0169E8}"/>
              </a:ext>
            </a:extLst>
          </p:cNvPr>
          <p:cNvSpPr txBox="1"/>
          <p:nvPr/>
        </p:nvSpPr>
        <p:spPr>
          <a:xfrm>
            <a:off x="11753256" y="2994143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300 bp</a:t>
            </a:r>
            <a:endParaRPr lang="en-BE" sz="8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527A82D-5736-2B23-A36C-25C941E32A60}"/>
              </a:ext>
            </a:extLst>
          </p:cNvPr>
          <p:cNvSpPr txBox="1"/>
          <p:nvPr/>
        </p:nvSpPr>
        <p:spPr>
          <a:xfrm>
            <a:off x="11753256" y="2911045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400 bp</a:t>
            </a:r>
            <a:endParaRPr lang="en-BE" sz="8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15146FB-EC19-CE17-C1A3-9E090D419166}"/>
              </a:ext>
            </a:extLst>
          </p:cNvPr>
          <p:cNvSpPr txBox="1"/>
          <p:nvPr/>
        </p:nvSpPr>
        <p:spPr>
          <a:xfrm>
            <a:off x="11753256" y="2830787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0 bp</a:t>
            </a:r>
            <a:endParaRPr lang="en-BE" sz="8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7C162C8-F516-D522-4DD1-EFE63312F3AA}"/>
              </a:ext>
            </a:extLst>
          </p:cNvPr>
          <p:cNvSpPr txBox="1"/>
          <p:nvPr/>
        </p:nvSpPr>
        <p:spPr>
          <a:xfrm>
            <a:off x="11761271" y="2744664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650 bp</a:t>
            </a:r>
            <a:endParaRPr lang="en-BE" sz="800" dirty="0"/>
          </a:p>
        </p:txBody>
      </p:sp>
    </p:spTree>
    <p:extLst>
      <p:ext uri="{BB962C8B-B14F-4D97-AF65-F5344CB8AC3E}">
        <p14:creationId xmlns:p14="http://schemas.microsoft.com/office/powerpoint/2010/main" val="27046756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C9C70900-D716-233B-E97A-EAB1425AD74A}"/>
              </a:ext>
            </a:extLst>
          </p:cNvPr>
          <p:cNvGrpSpPr/>
          <p:nvPr/>
        </p:nvGrpSpPr>
        <p:grpSpPr>
          <a:xfrm>
            <a:off x="4358682" y="2296764"/>
            <a:ext cx="2229253" cy="2655599"/>
            <a:chOff x="5839624" y="2584149"/>
            <a:chExt cx="2256773" cy="2780376"/>
          </a:xfrm>
        </p:grpSpPr>
        <p:pic>
          <p:nvPicPr>
            <p:cNvPr id="14" name="Picture 13" descr="A close-up of a dna test">
              <a:extLst>
                <a:ext uri="{FF2B5EF4-FFF2-40B4-BE49-F238E27FC236}">
                  <a16:creationId xmlns:a16="http://schemas.microsoft.com/office/drawing/2014/main" id="{D889EDB9-B014-50BE-2C10-45A4DCDB7BC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00" t="39649" r="43220" b="19808"/>
            <a:stretch>
              <a:fillRect/>
            </a:stretch>
          </p:blipFill>
          <p:spPr>
            <a:xfrm>
              <a:off x="5839624" y="2584149"/>
              <a:ext cx="2256773" cy="2780376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D987980-9EE1-A894-7106-A6A3F7DC0743}"/>
                </a:ext>
              </a:extLst>
            </p:cNvPr>
            <p:cNvSpPr txBox="1"/>
            <p:nvPr/>
          </p:nvSpPr>
          <p:spPr>
            <a:xfrm>
              <a:off x="5900624" y="4938357"/>
              <a:ext cx="2147640" cy="290014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i="1" dirty="0"/>
                <a:t>Dm-</a:t>
              </a:r>
              <a:r>
                <a:rPr lang="en-US" sz="1200" dirty="0"/>
                <a:t>Rp49 (341 bp)</a:t>
              </a:r>
            </a:p>
          </p:txBody>
        </p: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64640096-87C6-7CF0-502C-CCFA4EFCF742}"/>
              </a:ext>
            </a:extLst>
          </p:cNvPr>
          <p:cNvSpPr txBox="1"/>
          <p:nvPr/>
        </p:nvSpPr>
        <p:spPr>
          <a:xfrm>
            <a:off x="548503" y="1577729"/>
            <a:ext cx="643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NA</a:t>
            </a:r>
            <a:endParaRPr lang="en-BE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72823ED-2EA5-1356-5B09-249548DA7239}"/>
              </a:ext>
            </a:extLst>
          </p:cNvPr>
          <p:cNvSpPr txBox="1"/>
          <p:nvPr/>
        </p:nvSpPr>
        <p:spPr>
          <a:xfrm>
            <a:off x="1303465" y="1577729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NA</a:t>
            </a:r>
            <a:endParaRPr lang="en-BE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0366586-CE1E-8582-4E5C-C623D39B6735}"/>
              </a:ext>
            </a:extLst>
          </p:cNvPr>
          <p:cNvSpPr txBox="1"/>
          <p:nvPr/>
        </p:nvSpPr>
        <p:spPr>
          <a:xfrm>
            <a:off x="521967" y="1979227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B3CCF96-2558-3FB4-1A61-0B3B0A320AF3}"/>
              </a:ext>
            </a:extLst>
          </p:cNvPr>
          <p:cNvSpPr txBox="1"/>
          <p:nvPr/>
        </p:nvSpPr>
        <p:spPr>
          <a:xfrm>
            <a:off x="870977" y="1979227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00AEA32-5B6F-15EE-7D42-BBA6DD4BC5CD}"/>
              </a:ext>
            </a:extLst>
          </p:cNvPr>
          <p:cNvSpPr txBox="1"/>
          <p:nvPr/>
        </p:nvSpPr>
        <p:spPr>
          <a:xfrm>
            <a:off x="1265074" y="1979227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B106010-9954-EB71-C343-16E1A24B29AC}"/>
              </a:ext>
            </a:extLst>
          </p:cNvPr>
          <p:cNvSpPr txBox="1"/>
          <p:nvPr/>
        </p:nvSpPr>
        <p:spPr>
          <a:xfrm>
            <a:off x="1581281" y="1979227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ACD7756B-AE80-7421-687F-EFD3F0E7C17F}"/>
              </a:ext>
            </a:extLst>
          </p:cNvPr>
          <p:cNvSpPr txBox="1"/>
          <p:nvPr/>
        </p:nvSpPr>
        <p:spPr>
          <a:xfrm>
            <a:off x="2656436" y="1979227"/>
            <a:ext cx="245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-</a:t>
            </a:r>
            <a:endParaRPr lang="en-BE" sz="1400" dirty="0"/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29813398-D006-0809-3D60-75F039216DE8}"/>
              </a:ext>
            </a:extLst>
          </p:cNvPr>
          <p:cNvCxnSpPr>
            <a:cxnSpLocks/>
          </p:cNvCxnSpPr>
          <p:nvPr/>
        </p:nvCxnSpPr>
        <p:spPr>
          <a:xfrm>
            <a:off x="622894" y="1955649"/>
            <a:ext cx="568734" cy="465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6F1909D3-FB08-DE03-4060-BAF9935ADAD8}"/>
              </a:ext>
            </a:extLst>
          </p:cNvPr>
          <p:cNvCxnSpPr>
            <a:cxnSpLocks/>
          </p:cNvCxnSpPr>
          <p:nvPr/>
        </p:nvCxnSpPr>
        <p:spPr>
          <a:xfrm>
            <a:off x="4712913" y="1957974"/>
            <a:ext cx="64618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9B7BAC81-B6E9-AEFD-2447-AEA722667759}"/>
              </a:ext>
            </a:extLst>
          </p:cNvPr>
          <p:cNvCxnSpPr>
            <a:cxnSpLocks/>
          </p:cNvCxnSpPr>
          <p:nvPr/>
        </p:nvCxnSpPr>
        <p:spPr>
          <a:xfrm>
            <a:off x="1303465" y="1955649"/>
            <a:ext cx="568734" cy="465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55FFEAB4-137C-C9FE-49A7-BD62D43D8161}"/>
              </a:ext>
            </a:extLst>
          </p:cNvPr>
          <p:cNvCxnSpPr>
            <a:cxnSpLocks/>
          </p:cNvCxnSpPr>
          <p:nvPr/>
        </p:nvCxnSpPr>
        <p:spPr>
          <a:xfrm>
            <a:off x="1970842" y="1955649"/>
            <a:ext cx="568734" cy="465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TextBox 64">
            <a:extLst>
              <a:ext uri="{FF2B5EF4-FFF2-40B4-BE49-F238E27FC236}">
                <a16:creationId xmlns:a16="http://schemas.microsoft.com/office/drawing/2014/main" id="{A1E23C4B-EC96-5BC6-6D91-BFDF38F9212B}"/>
              </a:ext>
            </a:extLst>
          </p:cNvPr>
          <p:cNvSpPr txBox="1"/>
          <p:nvPr/>
        </p:nvSpPr>
        <p:spPr>
          <a:xfrm>
            <a:off x="1950235" y="1423841"/>
            <a:ext cx="8813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Digested DNA</a:t>
            </a:r>
            <a:endParaRPr lang="en-BE" sz="1400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2831DBF0-6BBD-FDE2-812A-C7FE5E686318}"/>
              </a:ext>
            </a:extLst>
          </p:cNvPr>
          <p:cNvSpPr txBox="1"/>
          <p:nvPr/>
        </p:nvSpPr>
        <p:spPr>
          <a:xfrm>
            <a:off x="1946132" y="1979227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F63889A-62CF-EECC-F7BE-D9719BD2FA8F}"/>
              </a:ext>
            </a:extLst>
          </p:cNvPr>
          <p:cNvSpPr txBox="1"/>
          <p:nvPr/>
        </p:nvSpPr>
        <p:spPr>
          <a:xfrm>
            <a:off x="2291979" y="1979227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B16EB0EF-F000-28FF-8D22-F326B6D2344C}"/>
              </a:ext>
            </a:extLst>
          </p:cNvPr>
          <p:cNvCxnSpPr>
            <a:cxnSpLocks/>
          </p:cNvCxnSpPr>
          <p:nvPr/>
        </p:nvCxnSpPr>
        <p:spPr>
          <a:xfrm>
            <a:off x="5544395" y="1957974"/>
            <a:ext cx="629305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65A23829-E6D7-8E59-1C6C-C7EC4E9D8785}"/>
              </a:ext>
            </a:extLst>
          </p:cNvPr>
          <p:cNvSpPr txBox="1"/>
          <p:nvPr/>
        </p:nvSpPr>
        <p:spPr>
          <a:xfrm>
            <a:off x="4777183" y="157772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0</a:t>
            </a:r>
            <a:endParaRPr lang="en-BE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54AAC59-1844-F3E3-7ED4-092C85C4B649}"/>
              </a:ext>
            </a:extLst>
          </p:cNvPr>
          <p:cNvSpPr txBox="1"/>
          <p:nvPr/>
        </p:nvSpPr>
        <p:spPr>
          <a:xfrm>
            <a:off x="5625040" y="157772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3</a:t>
            </a:r>
            <a:endParaRPr lang="en-BE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1DFB968D-BA51-098D-4A62-99D09A8F04FB}"/>
              </a:ext>
            </a:extLst>
          </p:cNvPr>
          <p:cNvSpPr txBox="1"/>
          <p:nvPr/>
        </p:nvSpPr>
        <p:spPr>
          <a:xfrm>
            <a:off x="4706773" y="1979227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967D38A8-B62A-A22C-8875-CF9E88C93891}"/>
              </a:ext>
            </a:extLst>
          </p:cNvPr>
          <p:cNvSpPr txBox="1"/>
          <p:nvPr/>
        </p:nvSpPr>
        <p:spPr>
          <a:xfrm>
            <a:off x="5079629" y="1979227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AED5BA51-3D51-2758-430A-368B38D9C6B3}"/>
              </a:ext>
            </a:extLst>
          </p:cNvPr>
          <p:cNvSpPr txBox="1"/>
          <p:nvPr/>
        </p:nvSpPr>
        <p:spPr>
          <a:xfrm>
            <a:off x="5473309" y="1979227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35905554-E576-148D-E3E4-2F4BF4F659E9}"/>
              </a:ext>
            </a:extLst>
          </p:cNvPr>
          <p:cNvSpPr txBox="1"/>
          <p:nvPr/>
        </p:nvSpPr>
        <p:spPr>
          <a:xfrm>
            <a:off x="5817194" y="1979227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F65109C-0B76-52AF-A316-644B13BA79B0}"/>
              </a:ext>
            </a:extLst>
          </p:cNvPr>
          <p:cNvSpPr txBox="1"/>
          <p:nvPr/>
        </p:nvSpPr>
        <p:spPr>
          <a:xfrm>
            <a:off x="6225444" y="1979227"/>
            <a:ext cx="245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-</a:t>
            </a:r>
            <a:endParaRPr lang="en-BE" sz="1400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C8D30FD3-243C-AED5-C6CB-92938C229661}"/>
              </a:ext>
            </a:extLst>
          </p:cNvPr>
          <p:cNvSpPr txBox="1"/>
          <p:nvPr/>
        </p:nvSpPr>
        <p:spPr>
          <a:xfrm>
            <a:off x="7183697" y="1979227"/>
            <a:ext cx="4192338" cy="42473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Figure S1 B:</a:t>
            </a:r>
            <a:r>
              <a:rPr lang="en-US" dirty="0"/>
              <a:t> Amplicons produced with </a:t>
            </a:r>
            <a:r>
              <a:rPr lang="en-US" dirty="0" err="1"/>
              <a:t>CrPV</a:t>
            </a:r>
            <a:r>
              <a:rPr lang="en-US" dirty="0"/>
              <a:t>-specific primer pair 7 from DNA, RNA, or digested DNA from virus-infected (V) or mock-infected (M) cells. </a:t>
            </a:r>
            <a:r>
              <a:rPr lang="en-US" b="1" dirty="0"/>
              <a:t>C:</a:t>
            </a:r>
            <a:r>
              <a:rPr lang="en-US" dirty="0"/>
              <a:t> Amplicons produced with </a:t>
            </a:r>
            <a:r>
              <a:rPr lang="en-US" i="1" dirty="0"/>
              <a:t>Dm</a:t>
            </a:r>
            <a:r>
              <a:rPr lang="en-US" dirty="0"/>
              <a:t>Rp49-specific primers from DNA of cells collected immediately (T0) or three days (T3) after viral infection (V) or mock-infection (M). -: non-template control. The </a:t>
            </a:r>
            <a:r>
              <a:rPr lang="en-US" dirty="0" err="1"/>
              <a:t>Thermo</a:t>
            </a:r>
            <a:r>
              <a:rPr lang="en-US" dirty="0"/>
              <a:t> Fisher Scientific 1 </a:t>
            </a:r>
            <a:r>
              <a:rPr lang="en-US" dirty="0" err="1"/>
              <a:t>Kb</a:t>
            </a:r>
            <a:r>
              <a:rPr lang="en-US" dirty="0"/>
              <a:t> Plus DNA ladder was used as a reference for panel B, while the </a:t>
            </a:r>
            <a:r>
              <a:rPr lang="en-US" dirty="0" err="1"/>
              <a:t>Thermo</a:t>
            </a:r>
            <a:r>
              <a:rPr lang="en-US" dirty="0"/>
              <a:t> Fisher Scientific </a:t>
            </a:r>
            <a:r>
              <a:rPr lang="en-US" dirty="0" err="1"/>
              <a:t>GeneRuler</a:t>
            </a:r>
            <a:r>
              <a:rPr lang="en-US" dirty="0"/>
              <a:t> 100 bp DNA ladder was used as a reference for panel C.</a:t>
            </a:r>
            <a:endParaRPr lang="en-BE" dirty="0"/>
          </a:p>
          <a:p>
            <a:endParaRPr lang="en-BE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6D40EE9-FF7F-98A7-8DC8-ADD8314FDD4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7098" t="25690" r="14348" b="38257"/>
          <a:stretch>
            <a:fillRect/>
          </a:stretch>
        </p:blipFill>
        <p:spPr>
          <a:xfrm>
            <a:off x="469596" y="2305931"/>
            <a:ext cx="2804297" cy="2655599"/>
          </a:xfrm>
          <a:prstGeom prst="rect">
            <a:avLst/>
          </a:prstGeom>
        </p:spPr>
      </p:pic>
      <p:sp>
        <p:nvSpPr>
          <p:cNvPr id="12" name="TextBox 1">
            <a:extLst>
              <a:ext uri="{FF2B5EF4-FFF2-40B4-BE49-F238E27FC236}">
                <a16:creationId xmlns:a16="http://schemas.microsoft.com/office/drawing/2014/main" id="{91714B4E-170F-7FFE-74DD-C319DB4A077F}"/>
              </a:ext>
            </a:extLst>
          </p:cNvPr>
          <p:cNvSpPr txBox="1"/>
          <p:nvPr/>
        </p:nvSpPr>
        <p:spPr>
          <a:xfrm>
            <a:off x="666972" y="4545320"/>
            <a:ext cx="2409546" cy="276999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/>
              <a:t>CrPV_pair-7 (127 bp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837A975-A5D0-5008-BAD5-A2123A11C876}"/>
              </a:ext>
            </a:extLst>
          </p:cNvPr>
          <p:cNvSpPr txBox="1"/>
          <p:nvPr/>
        </p:nvSpPr>
        <p:spPr>
          <a:xfrm>
            <a:off x="360704" y="100764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  <a:endParaRPr lang="en-BE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4179B34-9006-CBCC-78DF-DA070896D336}"/>
              </a:ext>
            </a:extLst>
          </p:cNvPr>
          <p:cNvSpPr txBox="1"/>
          <p:nvPr/>
        </p:nvSpPr>
        <p:spPr>
          <a:xfrm>
            <a:off x="4288326" y="1007648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C</a:t>
            </a:r>
            <a:endParaRPr lang="en-BE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05F46A2-4D3D-969B-EA29-E31FFD78B07A}"/>
              </a:ext>
            </a:extLst>
          </p:cNvPr>
          <p:cNvSpPr txBox="1"/>
          <p:nvPr/>
        </p:nvSpPr>
        <p:spPr>
          <a:xfrm>
            <a:off x="3224297" y="3913700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100 bp</a:t>
            </a:r>
            <a:endParaRPr lang="en-BE" sz="8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A4325AB-CDA1-1D28-551A-63A43A3318C1}"/>
              </a:ext>
            </a:extLst>
          </p:cNvPr>
          <p:cNvSpPr txBox="1"/>
          <p:nvPr/>
        </p:nvSpPr>
        <p:spPr>
          <a:xfrm>
            <a:off x="3224297" y="3698750"/>
            <a:ext cx="4924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200</a:t>
            </a:r>
            <a:r>
              <a:rPr lang="en-GB" sz="1100" dirty="0"/>
              <a:t> </a:t>
            </a:r>
            <a:r>
              <a:rPr lang="en-GB" sz="800" dirty="0"/>
              <a:t>bp</a:t>
            </a:r>
            <a:endParaRPr lang="en-BE" sz="8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0329E13-340C-55BF-9B56-DFD8C2E1FB82}"/>
              </a:ext>
            </a:extLst>
          </p:cNvPr>
          <p:cNvSpPr txBox="1"/>
          <p:nvPr/>
        </p:nvSpPr>
        <p:spPr>
          <a:xfrm>
            <a:off x="3224297" y="3626543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300 bp</a:t>
            </a:r>
            <a:endParaRPr lang="en-BE" sz="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47FEC6A-275C-0A53-9D41-B91F2EF27CAC}"/>
              </a:ext>
            </a:extLst>
          </p:cNvPr>
          <p:cNvSpPr txBox="1"/>
          <p:nvPr/>
        </p:nvSpPr>
        <p:spPr>
          <a:xfrm>
            <a:off x="3224297" y="3554830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400 bp</a:t>
            </a:r>
            <a:endParaRPr lang="en-BE" sz="8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70684B0-A156-2BF8-C4D6-CA709B6C43B2}"/>
              </a:ext>
            </a:extLst>
          </p:cNvPr>
          <p:cNvSpPr txBox="1"/>
          <p:nvPr/>
        </p:nvSpPr>
        <p:spPr>
          <a:xfrm>
            <a:off x="3224297" y="3478674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0 bp</a:t>
            </a:r>
            <a:endParaRPr lang="en-BE" sz="8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551B01A-7C01-7A05-4AFC-D319CBFF70D5}"/>
              </a:ext>
            </a:extLst>
          </p:cNvPr>
          <p:cNvSpPr txBox="1"/>
          <p:nvPr/>
        </p:nvSpPr>
        <p:spPr>
          <a:xfrm>
            <a:off x="3224297" y="3401636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650 bp</a:t>
            </a:r>
            <a:endParaRPr lang="en-BE" sz="8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F830465-9A34-B0BC-CA6F-DFDBDAE27822}"/>
              </a:ext>
            </a:extLst>
          </p:cNvPr>
          <p:cNvSpPr txBox="1"/>
          <p:nvPr/>
        </p:nvSpPr>
        <p:spPr>
          <a:xfrm>
            <a:off x="3934510" y="4101838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100 bp</a:t>
            </a:r>
            <a:endParaRPr lang="en-BE" sz="8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A3690CA-1B1C-8E7C-E58C-556D350EE369}"/>
              </a:ext>
            </a:extLst>
          </p:cNvPr>
          <p:cNvSpPr txBox="1"/>
          <p:nvPr/>
        </p:nvSpPr>
        <p:spPr>
          <a:xfrm>
            <a:off x="3926495" y="3945851"/>
            <a:ext cx="4924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200</a:t>
            </a:r>
            <a:r>
              <a:rPr lang="en-GB" sz="1100" dirty="0"/>
              <a:t> </a:t>
            </a:r>
            <a:r>
              <a:rPr lang="en-GB" sz="800" dirty="0"/>
              <a:t>bp</a:t>
            </a:r>
            <a:endParaRPr lang="en-BE" sz="8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3C99E24-C17D-5F7A-26ED-1A562FD96CA7}"/>
              </a:ext>
            </a:extLst>
          </p:cNvPr>
          <p:cNvSpPr txBox="1"/>
          <p:nvPr/>
        </p:nvSpPr>
        <p:spPr>
          <a:xfrm>
            <a:off x="3934510" y="3852638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300 bp</a:t>
            </a:r>
            <a:endParaRPr lang="en-BE" sz="8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A5E11AF-A074-4A06-E881-C2B105E6B164}"/>
              </a:ext>
            </a:extLst>
          </p:cNvPr>
          <p:cNvSpPr txBox="1"/>
          <p:nvPr/>
        </p:nvSpPr>
        <p:spPr>
          <a:xfrm>
            <a:off x="3934510" y="3773792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400 bp</a:t>
            </a:r>
            <a:endParaRPr lang="en-BE" sz="800" dirty="0"/>
          </a:p>
        </p:txBody>
      </p:sp>
    </p:spTree>
    <p:extLst>
      <p:ext uri="{BB962C8B-B14F-4D97-AF65-F5344CB8AC3E}">
        <p14:creationId xmlns:p14="http://schemas.microsoft.com/office/powerpoint/2010/main" val="17690090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7C0A308-B7BF-761A-A070-1610B468C88B}"/>
              </a:ext>
            </a:extLst>
          </p:cNvPr>
          <p:cNvGrpSpPr/>
          <p:nvPr/>
        </p:nvGrpSpPr>
        <p:grpSpPr>
          <a:xfrm>
            <a:off x="730130" y="1594855"/>
            <a:ext cx="8181214" cy="3398826"/>
            <a:chOff x="74701" y="2234331"/>
            <a:chExt cx="8181214" cy="3398826"/>
          </a:xfrm>
        </p:grpSpPr>
        <p:pic>
          <p:nvPicPr>
            <p:cNvPr id="5" name="Picture 4" descr="A close-up of a rectangular object&#10;&#10;Description automatically generated">
              <a:extLst>
                <a:ext uri="{FF2B5EF4-FFF2-40B4-BE49-F238E27FC236}">
                  <a16:creationId xmlns:a16="http://schemas.microsoft.com/office/drawing/2014/main" id="{EE0C829F-63A8-1B7E-B5AE-ED997A0FA4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076" t="31749" r="18049" b="18756"/>
            <a:stretch>
              <a:fillRect/>
            </a:stretch>
          </p:blipFill>
          <p:spPr>
            <a:xfrm>
              <a:off x="74701" y="2238822"/>
              <a:ext cx="5292235" cy="3394335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761D8A2-5A8B-5075-3CCE-958A58C64350}"/>
                </a:ext>
              </a:extLst>
            </p:cNvPr>
            <p:cNvSpPr txBox="1"/>
            <p:nvPr/>
          </p:nvSpPr>
          <p:spPr>
            <a:xfrm>
              <a:off x="135110" y="5270709"/>
              <a:ext cx="5171416" cy="27699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US" sz="1200" dirty="0"/>
                <a:t>CrPV_pair-5 (223 bp)</a:t>
              </a:r>
            </a:p>
          </p:txBody>
        </p:sp>
        <p:pic>
          <p:nvPicPr>
            <p:cNvPr id="18" name="Picture 17" descr="A white paper with a few white strips&#10;&#10;AI-generated content may be incorrect.">
              <a:extLst>
                <a:ext uri="{FF2B5EF4-FFF2-40B4-BE49-F238E27FC236}">
                  <a16:creationId xmlns:a16="http://schemas.microsoft.com/office/drawing/2014/main" id="{A713EEDD-4FCF-E386-837D-8F62BBDC911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054" t="30593" r="35383" b="40597"/>
            <a:stretch>
              <a:fillRect/>
            </a:stretch>
          </p:blipFill>
          <p:spPr>
            <a:xfrm>
              <a:off x="6082458" y="2234331"/>
              <a:ext cx="2173457" cy="1767899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79609C42-8597-9B13-5641-5DDF22907B90}"/>
                </a:ext>
              </a:extLst>
            </p:cNvPr>
            <p:cNvSpPr txBox="1"/>
            <p:nvPr/>
          </p:nvSpPr>
          <p:spPr>
            <a:xfrm>
              <a:off x="6185597" y="3658990"/>
              <a:ext cx="1967178" cy="276999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US" sz="1200" i="1" dirty="0"/>
                <a:t>Tn-</a:t>
              </a:r>
              <a:r>
                <a:rPr lang="en-US" sz="1200" dirty="0"/>
                <a:t>RpL32 (260 bp)</a:t>
              </a:r>
            </a:p>
          </p:txBody>
        </p:sp>
      </p:grp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87EF7200-4E91-1A26-8889-A32CF7CDB09C}"/>
              </a:ext>
            </a:extLst>
          </p:cNvPr>
          <p:cNvCxnSpPr>
            <a:cxnSpLocks/>
          </p:cNvCxnSpPr>
          <p:nvPr/>
        </p:nvCxnSpPr>
        <p:spPr>
          <a:xfrm>
            <a:off x="1181579" y="1281546"/>
            <a:ext cx="64618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1BBBF771-1914-3E73-09B3-07B2873622C2}"/>
              </a:ext>
            </a:extLst>
          </p:cNvPr>
          <p:cNvCxnSpPr>
            <a:cxnSpLocks/>
          </p:cNvCxnSpPr>
          <p:nvPr/>
        </p:nvCxnSpPr>
        <p:spPr>
          <a:xfrm>
            <a:off x="1910115" y="1281546"/>
            <a:ext cx="629305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66428476-50DC-EEBB-C762-9A3D7CE78772}"/>
              </a:ext>
            </a:extLst>
          </p:cNvPr>
          <p:cNvSpPr txBox="1"/>
          <p:nvPr/>
        </p:nvSpPr>
        <p:spPr>
          <a:xfrm>
            <a:off x="1268041" y="90685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0</a:t>
            </a:r>
            <a:endParaRPr lang="en-BE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5BB04FE-B91D-5B6F-A104-A451F07792FE}"/>
              </a:ext>
            </a:extLst>
          </p:cNvPr>
          <p:cNvSpPr txBox="1"/>
          <p:nvPr/>
        </p:nvSpPr>
        <p:spPr>
          <a:xfrm>
            <a:off x="2046190" y="90685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3</a:t>
            </a:r>
            <a:endParaRPr lang="en-BE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BCD3091-97D7-D1A3-130B-01FA0A92B84C}"/>
              </a:ext>
            </a:extLst>
          </p:cNvPr>
          <p:cNvSpPr txBox="1"/>
          <p:nvPr/>
        </p:nvSpPr>
        <p:spPr>
          <a:xfrm>
            <a:off x="1197631" y="1296592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3F6A85F-7C81-E81D-84DB-DD3EC674F605}"/>
              </a:ext>
            </a:extLst>
          </p:cNvPr>
          <p:cNvSpPr txBox="1"/>
          <p:nvPr/>
        </p:nvSpPr>
        <p:spPr>
          <a:xfrm>
            <a:off x="1537304" y="1296592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62002F9-4CD9-2593-BC32-D050326452E5}"/>
              </a:ext>
            </a:extLst>
          </p:cNvPr>
          <p:cNvSpPr txBox="1"/>
          <p:nvPr/>
        </p:nvSpPr>
        <p:spPr>
          <a:xfrm>
            <a:off x="1920361" y="1296592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A8C4BBB-A5C2-A2A5-2DA9-FF9530705A01}"/>
              </a:ext>
            </a:extLst>
          </p:cNvPr>
          <p:cNvSpPr txBox="1"/>
          <p:nvPr/>
        </p:nvSpPr>
        <p:spPr>
          <a:xfrm>
            <a:off x="2224768" y="1296592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0DF5AC23-A4F3-D14D-E9E7-884D1850E7C3}"/>
              </a:ext>
            </a:extLst>
          </p:cNvPr>
          <p:cNvCxnSpPr>
            <a:cxnSpLocks/>
          </p:cNvCxnSpPr>
          <p:nvPr/>
        </p:nvCxnSpPr>
        <p:spPr>
          <a:xfrm>
            <a:off x="2624657" y="1281546"/>
            <a:ext cx="64618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E65E6FCB-AF8F-2656-A574-1A321D3A0B91}"/>
              </a:ext>
            </a:extLst>
          </p:cNvPr>
          <p:cNvCxnSpPr>
            <a:cxnSpLocks/>
          </p:cNvCxnSpPr>
          <p:nvPr/>
        </p:nvCxnSpPr>
        <p:spPr>
          <a:xfrm>
            <a:off x="3341886" y="1281546"/>
            <a:ext cx="629305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29B36D6E-F75F-39E8-DCD7-C389719A36D2}"/>
              </a:ext>
            </a:extLst>
          </p:cNvPr>
          <p:cNvSpPr txBox="1"/>
          <p:nvPr/>
        </p:nvSpPr>
        <p:spPr>
          <a:xfrm>
            <a:off x="2678489" y="90685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0</a:t>
            </a:r>
            <a:endParaRPr lang="en-BE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8947192-62A4-F2BB-1761-2E9C3B7D683E}"/>
              </a:ext>
            </a:extLst>
          </p:cNvPr>
          <p:cNvSpPr txBox="1"/>
          <p:nvPr/>
        </p:nvSpPr>
        <p:spPr>
          <a:xfrm>
            <a:off x="3456638" y="90685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3</a:t>
            </a:r>
            <a:endParaRPr lang="en-BE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F18FC75-060C-B400-B7C7-8A913C6F5487}"/>
              </a:ext>
            </a:extLst>
          </p:cNvPr>
          <p:cNvSpPr txBox="1"/>
          <p:nvPr/>
        </p:nvSpPr>
        <p:spPr>
          <a:xfrm>
            <a:off x="2608079" y="1296592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6965F0F-7A39-88E5-9430-40EC9F63EE9E}"/>
              </a:ext>
            </a:extLst>
          </p:cNvPr>
          <p:cNvSpPr txBox="1"/>
          <p:nvPr/>
        </p:nvSpPr>
        <p:spPr>
          <a:xfrm>
            <a:off x="2947752" y="1296592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B7ACDAE-9458-FD68-C75B-49C48C4329ED}"/>
              </a:ext>
            </a:extLst>
          </p:cNvPr>
          <p:cNvSpPr txBox="1"/>
          <p:nvPr/>
        </p:nvSpPr>
        <p:spPr>
          <a:xfrm>
            <a:off x="3330809" y="1296592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6A986DF-2FE0-9722-2EDA-C5563FF9D58A}"/>
              </a:ext>
            </a:extLst>
          </p:cNvPr>
          <p:cNvSpPr txBox="1"/>
          <p:nvPr/>
        </p:nvSpPr>
        <p:spPr>
          <a:xfrm>
            <a:off x="3635216" y="1296592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439A56A3-2C26-B23D-6F55-724DAEFDB337}"/>
              </a:ext>
            </a:extLst>
          </p:cNvPr>
          <p:cNvCxnSpPr>
            <a:cxnSpLocks/>
          </p:cNvCxnSpPr>
          <p:nvPr/>
        </p:nvCxnSpPr>
        <p:spPr>
          <a:xfrm>
            <a:off x="4316970" y="1281546"/>
            <a:ext cx="64618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F7086D84-967C-897E-2B65-5502FD0ABE0C}"/>
              </a:ext>
            </a:extLst>
          </p:cNvPr>
          <p:cNvCxnSpPr>
            <a:cxnSpLocks/>
          </p:cNvCxnSpPr>
          <p:nvPr/>
        </p:nvCxnSpPr>
        <p:spPr>
          <a:xfrm>
            <a:off x="5102002" y="1281546"/>
            <a:ext cx="498283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D3D5371B-93E8-447D-382F-19A1ABA1D662}"/>
              </a:ext>
            </a:extLst>
          </p:cNvPr>
          <p:cNvSpPr txBox="1"/>
          <p:nvPr/>
        </p:nvSpPr>
        <p:spPr>
          <a:xfrm>
            <a:off x="4403432" y="90685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0</a:t>
            </a:r>
            <a:endParaRPr lang="en-BE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1AF393B-CA6F-C01A-BFAD-FECE3E1285DD}"/>
              </a:ext>
            </a:extLst>
          </p:cNvPr>
          <p:cNvSpPr txBox="1"/>
          <p:nvPr/>
        </p:nvSpPr>
        <p:spPr>
          <a:xfrm>
            <a:off x="5181581" y="90685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3</a:t>
            </a:r>
            <a:endParaRPr lang="en-BE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D582776-32D1-DEE8-CA71-282CFED89463}"/>
              </a:ext>
            </a:extLst>
          </p:cNvPr>
          <p:cNvSpPr txBox="1"/>
          <p:nvPr/>
        </p:nvSpPr>
        <p:spPr>
          <a:xfrm>
            <a:off x="4333022" y="1296592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5840412-80D6-B0B2-C5B3-C41686C17E12}"/>
              </a:ext>
            </a:extLst>
          </p:cNvPr>
          <p:cNvSpPr txBox="1"/>
          <p:nvPr/>
        </p:nvSpPr>
        <p:spPr>
          <a:xfrm>
            <a:off x="4672695" y="1296592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72ECA75-6B41-60FB-5A07-7CB118C46266}"/>
              </a:ext>
            </a:extLst>
          </p:cNvPr>
          <p:cNvSpPr txBox="1"/>
          <p:nvPr/>
        </p:nvSpPr>
        <p:spPr>
          <a:xfrm>
            <a:off x="5055752" y="1296592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9AE6E98-F420-7BB3-DC6E-1CB4F0F2A1E7}"/>
              </a:ext>
            </a:extLst>
          </p:cNvPr>
          <p:cNvSpPr txBox="1"/>
          <p:nvPr/>
        </p:nvSpPr>
        <p:spPr>
          <a:xfrm>
            <a:off x="5360159" y="1296592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C9A1BFEC-3181-6727-E87D-8B1833F3FB82}"/>
              </a:ext>
            </a:extLst>
          </p:cNvPr>
          <p:cNvCxnSpPr>
            <a:cxnSpLocks/>
          </p:cNvCxnSpPr>
          <p:nvPr/>
        </p:nvCxnSpPr>
        <p:spPr>
          <a:xfrm>
            <a:off x="7179509" y="1275745"/>
            <a:ext cx="64618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120CBA0E-A469-6A9A-CC25-671C61C22B1C}"/>
              </a:ext>
            </a:extLst>
          </p:cNvPr>
          <p:cNvCxnSpPr>
            <a:cxnSpLocks/>
          </p:cNvCxnSpPr>
          <p:nvPr/>
        </p:nvCxnSpPr>
        <p:spPr>
          <a:xfrm>
            <a:off x="7933450" y="1275745"/>
            <a:ext cx="629305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07ECA0C6-F774-A43B-737E-9C8AF29915A6}"/>
              </a:ext>
            </a:extLst>
          </p:cNvPr>
          <p:cNvSpPr txBox="1"/>
          <p:nvPr/>
        </p:nvSpPr>
        <p:spPr>
          <a:xfrm>
            <a:off x="7243779" y="90105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0</a:t>
            </a:r>
            <a:endParaRPr lang="en-BE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5540001-94EC-14F5-960C-A24FCEE28908}"/>
              </a:ext>
            </a:extLst>
          </p:cNvPr>
          <p:cNvSpPr txBox="1"/>
          <p:nvPr/>
        </p:nvSpPr>
        <p:spPr>
          <a:xfrm>
            <a:off x="8021928" y="901055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3</a:t>
            </a:r>
            <a:endParaRPr lang="en-BE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A6AF679-E1E1-D325-F1C8-6B5781687A63}"/>
              </a:ext>
            </a:extLst>
          </p:cNvPr>
          <p:cNvSpPr txBox="1"/>
          <p:nvPr/>
        </p:nvSpPr>
        <p:spPr>
          <a:xfrm>
            <a:off x="7173369" y="1290791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964926F-6AC7-821A-729E-5354BCF7DC25}"/>
              </a:ext>
            </a:extLst>
          </p:cNvPr>
          <p:cNvSpPr txBox="1"/>
          <p:nvPr/>
        </p:nvSpPr>
        <p:spPr>
          <a:xfrm>
            <a:off x="7513042" y="1290791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6825835-3F3C-FE13-9A7E-D92BB2088F95}"/>
              </a:ext>
            </a:extLst>
          </p:cNvPr>
          <p:cNvSpPr txBox="1"/>
          <p:nvPr/>
        </p:nvSpPr>
        <p:spPr>
          <a:xfrm>
            <a:off x="7896099" y="1290791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32F9746-0B1A-5D98-626B-0448DF30B39C}"/>
              </a:ext>
            </a:extLst>
          </p:cNvPr>
          <p:cNvSpPr txBox="1"/>
          <p:nvPr/>
        </p:nvSpPr>
        <p:spPr>
          <a:xfrm>
            <a:off x="8200506" y="1290791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3584A98-9453-42E8-8060-0C6D6095E7A1}"/>
              </a:ext>
            </a:extLst>
          </p:cNvPr>
          <p:cNvSpPr txBox="1"/>
          <p:nvPr/>
        </p:nvSpPr>
        <p:spPr>
          <a:xfrm>
            <a:off x="8577108" y="1290791"/>
            <a:ext cx="245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-</a:t>
            </a:r>
            <a:endParaRPr lang="en-BE" sz="1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0822099-8CB2-41C9-C69A-46C2B0809FF3}"/>
              </a:ext>
            </a:extLst>
          </p:cNvPr>
          <p:cNvSpPr txBox="1"/>
          <p:nvPr/>
        </p:nvSpPr>
        <p:spPr>
          <a:xfrm>
            <a:off x="5731307" y="1296592"/>
            <a:ext cx="245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-</a:t>
            </a:r>
            <a:endParaRPr lang="en-BE" sz="14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3FECFCA-40BB-9AE1-60AB-086B00A8E3F2}"/>
              </a:ext>
            </a:extLst>
          </p:cNvPr>
          <p:cNvSpPr txBox="1"/>
          <p:nvPr/>
        </p:nvSpPr>
        <p:spPr>
          <a:xfrm>
            <a:off x="1588552" y="591026"/>
            <a:ext cx="643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NA</a:t>
            </a:r>
            <a:endParaRPr lang="en-BE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C577A131-5EA8-321C-AB99-840DB51D902E}"/>
              </a:ext>
            </a:extLst>
          </p:cNvPr>
          <p:cNvSpPr txBox="1"/>
          <p:nvPr/>
        </p:nvSpPr>
        <p:spPr>
          <a:xfrm>
            <a:off x="2947751" y="596827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NA</a:t>
            </a:r>
            <a:endParaRPr lang="en-BE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FC6CC82-DB0B-9AF6-A629-1EB03D194CF0}"/>
              </a:ext>
            </a:extLst>
          </p:cNvPr>
          <p:cNvSpPr txBox="1"/>
          <p:nvPr/>
        </p:nvSpPr>
        <p:spPr>
          <a:xfrm>
            <a:off x="4338465" y="599079"/>
            <a:ext cx="1261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Digested DNA</a:t>
            </a:r>
            <a:endParaRPr lang="en-BE" sz="14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3DDF8DD-F369-A735-8BDF-6F554B3A6AFC}"/>
              </a:ext>
            </a:extLst>
          </p:cNvPr>
          <p:cNvSpPr txBox="1"/>
          <p:nvPr/>
        </p:nvSpPr>
        <p:spPr>
          <a:xfrm>
            <a:off x="7548748" y="591026"/>
            <a:ext cx="643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NA</a:t>
            </a:r>
            <a:endParaRPr lang="en-BE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83F623D-BE5A-9F5F-F42E-CF23C2980436}"/>
              </a:ext>
            </a:extLst>
          </p:cNvPr>
          <p:cNvSpPr txBox="1"/>
          <p:nvPr/>
        </p:nvSpPr>
        <p:spPr>
          <a:xfrm>
            <a:off x="394251" y="5160598"/>
            <a:ext cx="11566080" cy="15640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800" b="1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Figure S2: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Presence of intracellular </a:t>
            </a:r>
            <a:r>
              <a:rPr lang="en-US" sz="1800" dirty="0" err="1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vDNA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from </a:t>
            </a:r>
            <a:r>
              <a:rPr lang="en-US" sz="1800" dirty="0" err="1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rPV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in High Five cells upon infection. </a:t>
            </a:r>
            <a:r>
              <a:rPr lang="en-US" b="1" dirty="0"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800" b="1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Amplicons produced with </a:t>
            </a:r>
            <a:r>
              <a:rPr lang="en-US" sz="1800" dirty="0" err="1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rPV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-specific primers (CrPV_pair-5) from DNA, RNA, or digested DNA, collected immediately (T0) or three days </a:t>
            </a:r>
            <a:r>
              <a:rPr lang="en-US" dirty="0"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(T3) 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after viral infection (V) or mock-infection (M) of cells. </a:t>
            </a:r>
            <a:r>
              <a:rPr lang="en-US" b="1" dirty="0"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800" b="1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Amplicons produced with </a:t>
            </a:r>
            <a:r>
              <a:rPr lang="en-US" sz="1800" i="1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Tn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RpL32-specific primers from DNA of cells collected immediately (T0) or three days (T3) after viral infection (V) or mock infection (M). -: non-template control. The </a:t>
            </a:r>
            <a:r>
              <a:rPr lang="en-US" sz="1800" dirty="0" err="1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Thermo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Fisher Scientific 1 </a:t>
            </a:r>
            <a:r>
              <a:rPr lang="en-US" dirty="0" err="1"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Kb</a:t>
            </a:r>
            <a:r>
              <a:rPr lang="en-US" dirty="0"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Plus 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DNA ladder was used as a reference.</a:t>
            </a:r>
            <a:endParaRPr lang="en-BE" sz="2800" dirty="0">
              <a:effectLst/>
              <a:latin typeface="Aptos" panose="020B00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B6004B8-ED0C-8561-785C-C27A37774245}"/>
              </a:ext>
            </a:extLst>
          </p:cNvPr>
          <p:cNvSpPr txBox="1"/>
          <p:nvPr/>
        </p:nvSpPr>
        <p:spPr>
          <a:xfrm>
            <a:off x="255806" y="3984042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100 bp</a:t>
            </a:r>
            <a:endParaRPr lang="en-BE" sz="8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E9B6412-09CF-E7D1-8E09-B04762CDFC05}"/>
              </a:ext>
            </a:extLst>
          </p:cNvPr>
          <p:cNvSpPr txBox="1"/>
          <p:nvPr/>
        </p:nvSpPr>
        <p:spPr>
          <a:xfrm>
            <a:off x="255806" y="3767789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200 bp</a:t>
            </a:r>
            <a:endParaRPr lang="en-BE" sz="8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33B3C53-CC80-24F2-BA46-7B6AD4CCE360}"/>
              </a:ext>
            </a:extLst>
          </p:cNvPr>
          <p:cNvSpPr txBox="1"/>
          <p:nvPr/>
        </p:nvSpPr>
        <p:spPr>
          <a:xfrm>
            <a:off x="255806" y="3581683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300 bp</a:t>
            </a:r>
            <a:endParaRPr lang="en-BE" sz="8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19DAE0B-D238-A620-9785-7947FD645F78}"/>
              </a:ext>
            </a:extLst>
          </p:cNvPr>
          <p:cNvSpPr txBox="1"/>
          <p:nvPr/>
        </p:nvSpPr>
        <p:spPr>
          <a:xfrm>
            <a:off x="255806" y="3460822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400 bp</a:t>
            </a:r>
            <a:endParaRPr lang="en-BE" sz="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A53EBD5-C063-FB64-3F5C-0F21995346D7}"/>
              </a:ext>
            </a:extLst>
          </p:cNvPr>
          <p:cNvSpPr txBox="1"/>
          <p:nvPr/>
        </p:nvSpPr>
        <p:spPr>
          <a:xfrm>
            <a:off x="255806" y="3337864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500 bp</a:t>
            </a:r>
            <a:endParaRPr lang="en-BE" sz="8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3A0945A-B61F-6AE8-9925-3FFA75DB2DE4}"/>
              </a:ext>
            </a:extLst>
          </p:cNvPr>
          <p:cNvSpPr txBox="1"/>
          <p:nvPr/>
        </p:nvSpPr>
        <p:spPr>
          <a:xfrm>
            <a:off x="255806" y="3210724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650 bp</a:t>
            </a:r>
            <a:endParaRPr lang="en-BE" sz="8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5C2E72C-25B7-E393-A741-60F53C5BAC79}"/>
              </a:ext>
            </a:extLst>
          </p:cNvPr>
          <p:cNvSpPr txBox="1"/>
          <p:nvPr/>
        </p:nvSpPr>
        <p:spPr>
          <a:xfrm>
            <a:off x="255806" y="3087162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850 bp</a:t>
            </a:r>
            <a:endParaRPr lang="en-BE" sz="8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1E41C0B-EF91-6A7C-CE02-66E78B09B1D8}"/>
              </a:ext>
            </a:extLst>
          </p:cNvPr>
          <p:cNvSpPr txBox="1"/>
          <p:nvPr/>
        </p:nvSpPr>
        <p:spPr>
          <a:xfrm>
            <a:off x="201304" y="2998033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1000 bp</a:t>
            </a:r>
            <a:endParaRPr lang="en-BE" sz="8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4D9C58C-1AE9-C568-25F2-B06FE202A910}"/>
              </a:ext>
            </a:extLst>
          </p:cNvPr>
          <p:cNvSpPr txBox="1"/>
          <p:nvPr/>
        </p:nvSpPr>
        <p:spPr>
          <a:xfrm>
            <a:off x="201304" y="2796854"/>
            <a:ext cx="5389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1500 bp</a:t>
            </a:r>
            <a:endParaRPr lang="en-BE" sz="8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C8E3D2B-973D-C869-BEBE-59254FABFE67}"/>
              </a:ext>
            </a:extLst>
          </p:cNvPr>
          <p:cNvSpPr txBox="1"/>
          <p:nvPr/>
        </p:nvSpPr>
        <p:spPr>
          <a:xfrm>
            <a:off x="6298937" y="2711355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100 bp</a:t>
            </a:r>
            <a:endParaRPr lang="en-BE" sz="8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A59B5B9-5FEF-BC4D-463E-9A03D0458091}"/>
              </a:ext>
            </a:extLst>
          </p:cNvPr>
          <p:cNvSpPr txBox="1"/>
          <p:nvPr/>
        </p:nvSpPr>
        <p:spPr>
          <a:xfrm>
            <a:off x="6298937" y="2630719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200 bp</a:t>
            </a:r>
            <a:endParaRPr lang="en-BE" sz="8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09E4D2F-A47F-DD9B-FB88-42EE81D57FE7}"/>
              </a:ext>
            </a:extLst>
          </p:cNvPr>
          <p:cNvSpPr txBox="1"/>
          <p:nvPr/>
        </p:nvSpPr>
        <p:spPr>
          <a:xfrm>
            <a:off x="6298937" y="2550082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300 bp</a:t>
            </a:r>
            <a:endParaRPr lang="en-BE" sz="8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AA24827-7A6B-B12F-0DDC-BC53A2ACD3F6}"/>
              </a:ext>
            </a:extLst>
          </p:cNvPr>
          <p:cNvSpPr txBox="1"/>
          <p:nvPr/>
        </p:nvSpPr>
        <p:spPr>
          <a:xfrm>
            <a:off x="630078" y="346695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  <a:endParaRPr lang="en-BE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36AE1BE-4EA5-6D8F-BF1B-41247FD1A3B5}"/>
              </a:ext>
            </a:extLst>
          </p:cNvPr>
          <p:cNvSpPr txBox="1"/>
          <p:nvPr/>
        </p:nvSpPr>
        <p:spPr>
          <a:xfrm>
            <a:off x="6678962" y="34669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  <a:endParaRPr lang="en-BE" dirty="0"/>
          </a:p>
        </p:txBody>
      </p:sp>
    </p:spTree>
    <p:extLst>
      <p:ext uri="{BB962C8B-B14F-4D97-AF65-F5344CB8AC3E}">
        <p14:creationId xmlns:p14="http://schemas.microsoft.com/office/powerpoint/2010/main" val="27331759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A3A73E9-BBEE-39D4-9EDD-4000327CE35A}"/>
              </a:ext>
            </a:extLst>
          </p:cNvPr>
          <p:cNvGrpSpPr/>
          <p:nvPr/>
        </p:nvGrpSpPr>
        <p:grpSpPr>
          <a:xfrm>
            <a:off x="684546" y="2044551"/>
            <a:ext cx="5671349" cy="2768898"/>
            <a:chOff x="3173303" y="2954502"/>
            <a:chExt cx="5671349" cy="2768898"/>
          </a:xfrm>
        </p:grpSpPr>
        <p:pic>
          <p:nvPicPr>
            <p:cNvPr id="4" name="Picture 3" descr="A close-up of a dna test&#10;&#10;Description automatically generated">
              <a:extLst>
                <a:ext uri="{FF2B5EF4-FFF2-40B4-BE49-F238E27FC236}">
                  <a16:creationId xmlns:a16="http://schemas.microsoft.com/office/drawing/2014/main" id="{E36AEAA5-F466-9AAD-B284-21B6F9EFC4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848" t="30109" r="23715" b="29766"/>
            <a:stretch/>
          </p:blipFill>
          <p:spPr>
            <a:xfrm>
              <a:off x="3173303" y="2965933"/>
              <a:ext cx="2600225" cy="2751692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5C89497-430E-A282-DE7E-3073810709B0}"/>
                </a:ext>
              </a:extLst>
            </p:cNvPr>
            <p:cNvSpPr txBox="1"/>
            <p:nvPr/>
          </p:nvSpPr>
          <p:spPr>
            <a:xfrm>
              <a:off x="3479446" y="5165492"/>
              <a:ext cx="735311" cy="553998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err="1"/>
                <a:t>CrPV</a:t>
              </a:r>
              <a:r>
                <a:rPr lang="en-US" sz="1000" dirty="0"/>
                <a:t>_</a:t>
              </a:r>
            </a:p>
            <a:p>
              <a:pPr algn="ctr"/>
              <a:r>
                <a:rPr lang="en-US" sz="1000" dirty="0"/>
                <a:t>pair-1 (226 bp)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9AFC4F8-038C-9FE4-65F4-76B1FB162449}"/>
                </a:ext>
              </a:extLst>
            </p:cNvPr>
            <p:cNvSpPr txBox="1"/>
            <p:nvPr/>
          </p:nvSpPr>
          <p:spPr>
            <a:xfrm>
              <a:off x="4253827" y="5165492"/>
              <a:ext cx="735311" cy="553998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err="1"/>
                <a:t>CrPV</a:t>
              </a:r>
              <a:r>
                <a:rPr lang="en-US" sz="1000" dirty="0"/>
                <a:t>_</a:t>
              </a:r>
            </a:p>
            <a:p>
              <a:pPr algn="ctr"/>
              <a:r>
                <a:rPr lang="en-US" sz="1000" dirty="0"/>
                <a:t>pair-5 (223 bp)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92DD09B-4FD5-456B-85CF-D7C0D1BC5906}"/>
                </a:ext>
              </a:extLst>
            </p:cNvPr>
            <p:cNvSpPr txBox="1"/>
            <p:nvPr/>
          </p:nvSpPr>
          <p:spPr>
            <a:xfrm>
              <a:off x="5038218" y="5165492"/>
              <a:ext cx="671774" cy="553998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err="1"/>
                <a:t>CrPV</a:t>
              </a:r>
              <a:r>
                <a:rPr lang="en-US" sz="1000" dirty="0"/>
                <a:t>_</a:t>
              </a:r>
            </a:p>
            <a:p>
              <a:pPr algn="ctr"/>
              <a:r>
                <a:rPr lang="en-US" sz="1000" dirty="0"/>
                <a:t>pair-7 (127 bp)</a:t>
              </a:r>
            </a:p>
          </p:txBody>
        </p:sp>
        <p:pic>
          <p:nvPicPr>
            <p:cNvPr id="14" name="Picture 13" descr="A close-up of a dna sequence&#10;&#10;Description automatically generated">
              <a:extLst>
                <a:ext uri="{FF2B5EF4-FFF2-40B4-BE49-F238E27FC236}">
                  <a16:creationId xmlns:a16="http://schemas.microsoft.com/office/drawing/2014/main" id="{6A33C505-7627-6AA4-AD5B-41D1BD9561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349" t="6791" r="49488" b="42301"/>
            <a:stretch/>
          </p:blipFill>
          <p:spPr>
            <a:xfrm>
              <a:off x="5953425" y="2954502"/>
              <a:ext cx="2891227" cy="2768898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F04FB57-854D-A587-A094-504CD8EAD776}"/>
                </a:ext>
              </a:extLst>
            </p:cNvPr>
            <p:cNvSpPr txBox="1"/>
            <p:nvPr/>
          </p:nvSpPr>
          <p:spPr>
            <a:xfrm>
              <a:off x="6077113" y="5442491"/>
              <a:ext cx="2643850" cy="246221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CrPV_pair-1 (226 bp)</a:t>
              </a:r>
            </a:p>
          </p:txBody>
        </p:sp>
      </p:grp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2DAD56B-C90F-4B8D-EAA9-D09A22AF93AF}"/>
              </a:ext>
            </a:extLst>
          </p:cNvPr>
          <p:cNvCxnSpPr>
            <a:cxnSpLocks/>
          </p:cNvCxnSpPr>
          <p:nvPr/>
        </p:nvCxnSpPr>
        <p:spPr>
          <a:xfrm>
            <a:off x="1116601" y="1681403"/>
            <a:ext cx="1959401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FB0ADFFC-0F57-8B6B-AE68-FABAD918643E}"/>
              </a:ext>
            </a:extLst>
          </p:cNvPr>
          <p:cNvSpPr txBox="1"/>
          <p:nvPr/>
        </p:nvSpPr>
        <p:spPr>
          <a:xfrm>
            <a:off x="1078892" y="1698861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945C008-BDE1-247D-9ADF-6DC48A32B733}"/>
              </a:ext>
            </a:extLst>
          </p:cNvPr>
          <p:cNvSpPr txBox="1"/>
          <p:nvPr/>
        </p:nvSpPr>
        <p:spPr>
          <a:xfrm>
            <a:off x="1445318" y="1698861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ED29C5B-354C-1A0A-7781-15BC984B5D34}"/>
              </a:ext>
            </a:extLst>
          </p:cNvPr>
          <p:cNvSpPr txBox="1"/>
          <p:nvPr/>
        </p:nvSpPr>
        <p:spPr>
          <a:xfrm>
            <a:off x="1811702" y="1698861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8473536-B877-C7CB-6D36-0539417AFBCC}"/>
              </a:ext>
            </a:extLst>
          </p:cNvPr>
          <p:cNvSpPr txBox="1"/>
          <p:nvPr/>
        </p:nvSpPr>
        <p:spPr>
          <a:xfrm>
            <a:off x="2168177" y="1698861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49DBA29-561F-8BF9-D263-CDA64E7E06CC}"/>
              </a:ext>
            </a:extLst>
          </p:cNvPr>
          <p:cNvSpPr txBox="1"/>
          <p:nvPr/>
        </p:nvSpPr>
        <p:spPr>
          <a:xfrm>
            <a:off x="1822593" y="1335467"/>
            <a:ext cx="643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NA</a:t>
            </a:r>
            <a:endParaRPr lang="en-BE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DD0178B-28AD-6462-04EE-4E4A0CF8D689}"/>
              </a:ext>
            </a:extLst>
          </p:cNvPr>
          <p:cNvSpPr txBox="1"/>
          <p:nvPr/>
        </p:nvSpPr>
        <p:spPr>
          <a:xfrm>
            <a:off x="2572489" y="1698861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E03A0D8-691C-EF22-C2B7-DE8B35C1D313}"/>
              </a:ext>
            </a:extLst>
          </p:cNvPr>
          <p:cNvSpPr txBox="1"/>
          <p:nvPr/>
        </p:nvSpPr>
        <p:spPr>
          <a:xfrm>
            <a:off x="2930770" y="1698861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3A8D1FE2-3810-484A-DC73-F2727F0A11AE}"/>
              </a:ext>
            </a:extLst>
          </p:cNvPr>
          <p:cNvCxnSpPr>
            <a:cxnSpLocks/>
          </p:cNvCxnSpPr>
          <p:nvPr/>
        </p:nvCxnSpPr>
        <p:spPr>
          <a:xfrm>
            <a:off x="3528325" y="1681403"/>
            <a:ext cx="64618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E854BC33-B8DE-BB19-D53C-322245469F86}"/>
              </a:ext>
            </a:extLst>
          </p:cNvPr>
          <p:cNvCxnSpPr>
            <a:cxnSpLocks/>
          </p:cNvCxnSpPr>
          <p:nvPr/>
        </p:nvCxnSpPr>
        <p:spPr>
          <a:xfrm>
            <a:off x="4282266" y="1681403"/>
            <a:ext cx="629305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8FF5D99F-94FA-ED0A-51C5-AFEDD59DF5DE}"/>
              </a:ext>
            </a:extLst>
          </p:cNvPr>
          <p:cNvSpPr txBox="1"/>
          <p:nvPr/>
        </p:nvSpPr>
        <p:spPr>
          <a:xfrm>
            <a:off x="3592595" y="1335467"/>
            <a:ext cx="6431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NA</a:t>
            </a:r>
            <a:endParaRPr lang="en-BE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78B00AE-5327-F3BB-2C1E-D0DCF7AF980D}"/>
              </a:ext>
            </a:extLst>
          </p:cNvPr>
          <p:cNvSpPr txBox="1"/>
          <p:nvPr/>
        </p:nvSpPr>
        <p:spPr>
          <a:xfrm>
            <a:off x="4322951" y="1335467"/>
            <a:ext cx="6238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NA</a:t>
            </a:r>
            <a:endParaRPr lang="en-BE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3DB0405-933A-5F05-8C1C-F12CE6842837}"/>
              </a:ext>
            </a:extLst>
          </p:cNvPr>
          <p:cNvSpPr txBox="1"/>
          <p:nvPr/>
        </p:nvSpPr>
        <p:spPr>
          <a:xfrm>
            <a:off x="3522185" y="1698861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FA77AAD-53BA-87B1-220B-B5B64A733247}"/>
              </a:ext>
            </a:extLst>
          </p:cNvPr>
          <p:cNvSpPr txBox="1"/>
          <p:nvPr/>
        </p:nvSpPr>
        <p:spPr>
          <a:xfrm>
            <a:off x="3861858" y="1698861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386EC47-0A04-7FCF-953A-D8E70584D3F9}"/>
              </a:ext>
            </a:extLst>
          </p:cNvPr>
          <p:cNvSpPr txBox="1"/>
          <p:nvPr/>
        </p:nvSpPr>
        <p:spPr>
          <a:xfrm>
            <a:off x="4244915" y="1698861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D19E046-3105-F58D-D813-192EF265D232}"/>
              </a:ext>
            </a:extLst>
          </p:cNvPr>
          <p:cNvSpPr txBox="1"/>
          <p:nvPr/>
        </p:nvSpPr>
        <p:spPr>
          <a:xfrm>
            <a:off x="4549322" y="1698861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9A63A60B-28A7-A376-6D85-ED60707CCCCC}"/>
              </a:ext>
            </a:extLst>
          </p:cNvPr>
          <p:cNvCxnSpPr>
            <a:cxnSpLocks/>
          </p:cNvCxnSpPr>
          <p:nvPr/>
        </p:nvCxnSpPr>
        <p:spPr>
          <a:xfrm>
            <a:off x="4966058" y="1681403"/>
            <a:ext cx="64618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9F1EDF7C-12F1-D29A-65B3-586D524E1514}"/>
              </a:ext>
            </a:extLst>
          </p:cNvPr>
          <p:cNvSpPr txBox="1"/>
          <p:nvPr/>
        </p:nvSpPr>
        <p:spPr>
          <a:xfrm>
            <a:off x="4982110" y="1698861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DAFBCCD-F641-5570-7E35-C50C7E20BE6F}"/>
              </a:ext>
            </a:extLst>
          </p:cNvPr>
          <p:cNvSpPr txBox="1"/>
          <p:nvPr/>
        </p:nvSpPr>
        <p:spPr>
          <a:xfrm>
            <a:off x="5321783" y="1698861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608DBD32-088A-295B-4181-2872DA6648DB}"/>
              </a:ext>
            </a:extLst>
          </p:cNvPr>
          <p:cNvSpPr txBox="1"/>
          <p:nvPr/>
        </p:nvSpPr>
        <p:spPr>
          <a:xfrm>
            <a:off x="4977826" y="1181579"/>
            <a:ext cx="100516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Digested DNA</a:t>
            </a:r>
            <a:endParaRPr lang="en-BE" sz="1400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835AD2FE-C54E-4A92-A972-07196FE377FE}"/>
              </a:ext>
            </a:extLst>
          </p:cNvPr>
          <p:cNvSpPr txBox="1"/>
          <p:nvPr/>
        </p:nvSpPr>
        <p:spPr>
          <a:xfrm>
            <a:off x="5653153" y="1698861"/>
            <a:ext cx="2455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-</a:t>
            </a:r>
            <a:endParaRPr lang="en-BE" sz="1400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7B6E1A8-3B4F-5A68-56E0-5E9C988CA12D}"/>
              </a:ext>
            </a:extLst>
          </p:cNvPr>
          <p:cNvSpPr txBox="1"/>
          <p:nvPr/>
        </p:nvSpPr>
        <p:spPr>
          <a:xfrm>
            <a:off x="6980012" y="1681403"/>
            <a:ext cx="4508968" cy="33421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800" b="1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Figure S3: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Presence of intracellular </a:t>
            </a:r>
            <a:r>
              <a:rPr lang="en-US" sz="1800" dirty="0" err="1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vDNA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from </a:t>
            </a:r>
            <a:r>
              <a:rPr lang="en-US" sz="1800" dirty="0" err="1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rPV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in BmN4 cells upon infection. </a:t>
            </a:r>
            <a:r>
              <a:rPr lang="en-US" sz="1800" b="1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A: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Amplicons produced with </a:t>
            </a:r>
            <a:r>
              <a:rPr lang="en-US" sz="1800" dirty="0" err="1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rPV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-specific primers from DNA of virus-infected (V) or mock-infected (M) cells. </a:t>
            </a:r>
            <a:r>
              <a:rPr lang="en-US" sz="1800" b="1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B: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Amplicons produced with </a:t>
            </a:r>
            <a:r>
              <a:rPr lang="en-US" sz="1800" dirty="0" err="1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rPV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-specific primers (CrPV_pair-1) from DNA, RNA, or digested DNA of virus-infected (V) or mock-infected (M) cells. -: non-template control. The </a:t>
            </a:r>
            <a:r>
              <a:rPr lang="en-US" sz="1800" dirty="0" err="1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Thermo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Fisher Scientific 1 </a:t>
            </a:r>
            <a:r>
              <a:rPr lang="en-US" sz="1800" dirty="0" err="1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Kb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Plus DNA ladder was used as a reference.</a:t>
            </a:r>
            <a:endParaRPr lang="en-BE" sz="2800" dirty="0">
              <a:effectLst/>
              <a:latin typeface="Aptos" panose="020B00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F2286C8-AF3F-7DCF-1178-5F3BCC077CD4}"/>
              </a:ext>
            </a:extLst>
          </p:cNvPr>
          <p:cNvSpPr txBox="1"/>
          <p:nvPr/>
        </p:nvSpPr>
        <p:spPr>
          <a:xfrm>
            <a:off x="262435" y="3757301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100 bp</a:t>
            </a:r>
            <a:endParaRPr lang="en-BE" sz="8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9EA9E11-02EB-793D-52FD-D1E7AF42AE89}"/>
              </a:ext>
            </a:extLst>
          </p:cNvPr>
          <p:cNvSpPr txBox="1"/>
          <p:nvPr/>
        </p:nvSpPr>
        <p:spPr>
          <a:xfrm>
            <a:off x="262435" y="3601786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200 bp</a:t>
            </a:r>
            <a:endParaRPr lang="en-BE" sz="8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63DA898-1195-F56D-5A70-30C412DFB340}"/>
              </a:ext>
            </a:extLst>
          </p:cNvPr>
          <p:cNvSpPr txBox="1"/>
          <p:nvPr/>
        </p:nvSpPr>
        <p:spPr>
          <a:xfrm>
            <a:off x="262435" y="3512657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300 bp</a:t>
            </a:r>
            <a:endParaRPr lang="en-BE" sz="8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133D744-A8CB-DF6C-1FA6-C498F93B6594}"/>
              </a:ext>
            </a:extLst>
          </p:cNvPr>
          <p:cNvSpPr txBox="1"/>
          <p:nvPr/>
        </p:nvSpPr>
        <p:spPr>
          <a:xfrm>
            <a:off x="262435" y="3442114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400 bp</a:t>
            </a:r>
            <a:endParaRPr lang="en-BE" sz="8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31FE24A-02C8-616B-12DB-6C646668CBEF}"/>
              </a:ext>
            </a:extLst>
          </p:cNvPr>
          <p:cNvSpPr txBox="1"/>
          <p:nvPr/>
        </p:nvSpPr>
        <p:spPr>
          <a:xfrm>
            <a:off x="6288202" y="3951189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100 bp</a:t>
            </a:r>
            <a:endParaRPr lang="en-BE" sz="8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70AB523-118D-6B0E-5A8D-126AB7F4F329}"/>
              </a:ext>
            </a:extLst>
          </p:cNvPr>
          <p:cNvSpPr txBox="1"/>
          <p:nvPr/>
        </p:nvSpPr>
        <p:spPr>
          <a:xfrm>
            <a:off x="6288202" y="3784842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200 bp</a:t>
            </a:r>
            <a:endParaRPr lang="en-BE" sz="8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09ABC3B-3DDF-7455-C639-2FFC79550B8F}"/>
              </a:ext>
            </a:extLst>
          </p:cNvPr>
          <p:cNvSpPr txBox="1"/>
          <p:nvPr/>
        </p:nvSpPr>
        <p:spPr>
          <a:xfrm>
            <a:off x="6288202" y="3657813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300 bp</a:t>
            </a:r>
            <a:endParaRPr lang="en-BE" sz="8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D5D148E-49A0-0ACB-765E-48E559AF3E0D}"/>
              </a:ext>
            </a:extLst>
          </p:cNvPr>
          <p:cNvSpPr txBox="1"/>
          <p:nvPr/>
        </p:nvSpPr>
        <p:spPr>
          <a:xfrm>
            <a:off x="6288202" y="3549836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400 bp</a:t>
            </a:r>
            <a:endParaRPr lang="en-BE" sz="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A757949-61CB-4A98-0D06-65A97EBD3E4F}"/>
              </a:ext>
            </a:extLst>
          </p:cNvPr>
          <p:cNvSpPr txBox="1"/>
          <p:nvPr/>
        </p:nvSpPr>
        <p:spPr>
          <a:xfrm>
            <a:off x="669767" y="684627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</a:t>
            </a:r>
            <a:endParaRPr lang="en-BE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B02CE07-11D1-7062-2EF7-C04BD9353EE7}"/>
              </a:ext>
            </a:extLst>
          </p:cNvPr>
          <p:cNvSpPr txBox="1"/>
          <p:nvPr/>
        </p:nvSpPr>
        <p:spPr>
          <a:xfrm>
            <a:off x="3537730" y="684627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</a:t>
            </a:r>
            <a:endParaRPr lang="en-BE" dirty="0"/>
          </a:p>
        </p:txBody>
      </p:sp>
    </p:spTree>
    <p:extLst>
      <p:ext uri="{BB962C8B-B14F-4D97-AF65-F5344CB8AC3E}">
        <p14:creationId xmlns:p14="http://schemas.microsoft.com/office/powerpoint/2010/main" val="41234181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439BC79-D228-8D53-50F9-A6539DD6B71C}"/>
              </a:ext>
            </a:extLst>
          </p:cNvPr>
          <p:cNvSpPr txBox="1"/>
          <p:nvPr/>
        </p:nvSpPr>
        <p:spPr>
          <a:xfrm>
            <a:off x="2941042" y="5488343"/>
            <a:ext cx="5966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100 bp</a:t>
            </a:r>
            <a:endParaRPr lang="en-BE" sz="11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D20A087-FA7A-4E95-61CB-74CD9120498F}"/>
              </a:ext>
            </a:extLst>
          </p:cNvPr>
          <p:cNvSpPr txBox="1"/>
          <p:nvPr/>
        </p:nvSpPr>
        <p:spPr>
          <a:xfrm>
            <a:off x="2941042" y="5357538"/>
            <a:ext cx="5966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200 bp</a:t>
            </a:r>
            <a:endParaRPr lang="en-BE" sz="11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AB35064-7ABF-9753-F1D3-4D1DDF1FB7DA}"/>
              </a:ext>
            </a:extLst>
          </p:cNvPr>
          <p:cNvSpPr txBox="1"/>
          <p:nvPr/>
        </p:nvSpPr>
        <p:spPr>
          <a:xfrm>
            <a:off x="2941042" y="5230304"/>
            <a:ext cx="5966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300 bp</a:t>
            </a:r>
            <a:endParaRPr lang="en-BE" sz="11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9BE06CB-3C5E-4E59-1B3C-554846C6C1E4}"/>
              </a:ext>
            </a:extLst>
          </p:cNvPr>
          <p:cNvSpPr txBox="1"/>
          <p:nvPr/>
        </p:nvSpPr>
        <p:spPr>
          <a:xfrm>
            <a:off x="2941042" y="5097714"/>
            <a:ext cx="5966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400 bp</a:t>
            </a:r>
            <a:endParaRPr lang="en-BE" sz="11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A4C1EDA-2377-2CB1-9DF6-C0E98D074E82}"/>
              </a:ext>
            </a:extLst>
          </p:cNvPr>
          <p:cNvSpPr txBox="1"/>
          <p:nvPr/>
        </p:nvSpPr>
        <p:spPr>
          <a:xfrm>
            <a:off x="2941042" y="4966909"/>
            <a:ext cx="5966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500 bp</a:t>
            </a:r>
            <a:endParaRPr lang="en-BE" sz="11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0EE4AA4-FE92-6AFD-4671-AF5C092FECE4}"/>
              </a:ext>
            </a:extLst>
          </p:cNvPr>
          <p:cNvSpPr txBox="1"/>
          <p:nvPr/>
        </p:nvSpPr>
        <p:spPr>
          <a:xfrm>
            <a:off x="2941042" y="4828472"/>
            <a:ext cx="5966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650 bp</a:t>
            </a:r>
            <a:endParaRPr lang="en-BE" sz="11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74DD897-97BD-ECCC-60AE-D997F072C084}"/>
              </a:ext>
            </a:extLst>
          </p:cNvPr>
          <p:cNvSpPr txBox="1"/>
          <p:nvPr/>
        </p:nvSpPr>
        <p:spPr>
          <a:xfrm>
            <a:off x="2941042" y="4688780"/>
            <a:ext cx="5966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850 bp</a:t>
            </a:r>
            <a:endParaRPr lang="en-BE" sz="11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9025C09-BA48-C4AC-A251-19A70B770A1D}"/>
              </a:ext>
            </a:extLst>
          </p:cNvPr>
          <p:cNvSpPr txBox="1"/>
          <p:nvPr/>
        </p:nvSpPr>
        <p:spPr>
          <a:xfrm>
            <a:off x="2941042" y="4556184"/>
            <a:ext cx="6719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1000 bp</a:t>
            </a:r>
            <a:endParaRPr lang="en-BE" sz="11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D79EE61-714C-CCE4-92B1-9B3CEECBAAF8}"/>
              </a:ext>
            </a:extLst>
          </p:cNvPr>
          <p:cNvSpPr txBox="1"/>
          <p:nvPr/>
        </p:nvSpPr>
        <p:spPr>
          <a:xfrm>
            <a:off x="2941042" y="4342966"/>
            <a:ext cx="6719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/>
              <a:t>1500 bp</a:t>
            </a:r>
            <a:endParaRPr lang="en-BE" sz="1100" dirty="0"/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BB0F97A-6528-EA72-121C-2C49E78FFCA1}"/>
              </a:ext>
            </a:extLst>
          </p:cNvPr>
          <p:cNvCxnSpPr>
            <a:cxnSpLocks/>
          </p:cNvCxnSpPr>
          <p:nvPr/>
        </p:nvCxnSpPr>
        <p:spPr>
          <a:xfrm>
            <a:off x="1331523" y="2803061"/>
            <a:ext cx="646189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F69BCFE0-DE27-9146-6A44-1AB55B5311B9}"/>
              </a:ext>
            </a:extLst>
          </p:cNvPr>
          <p:cNvSpPr txBox="1"/>
          <p:nvPr/>
        </p:nvSpPr>
        <p:spPr>
          <a:xfrm>
            <a:off x="1372951" y="2453038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4 dpi</a:t>
            </a:r>
            <a:endParaRPr lang="en-BE" sz="14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A927B8C-3E18-35EF-C254-11F3573B1042}"/>
              </a:ext>
            </a:extLst>
          </p:cNvPr>
          <p:cNvSpPr txBox="1"/>
          <p:nvPr/>
        </p:nvSpPr>
        <p:spPr>
          <a:xfrm>
            <a:off x="1977712" y="2453038"/>
            <a:ext cx="87588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9 dpi</a:t>
            </a:r>
            <a:endParaRPr lang="en-BE" sz="14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8FDE646-6A9D-BB19-DAB4-40C217416C2F}"/>
              </a:ext>
            </a:extLst>
          </p:cNvPr>
          <p:cNvSpPr txBox="1"/>
          <p:nvPr/>
        </p:nvSpPr>
        <p:spPr>
          <a:xfrm>
            <a:off x="1347575" y="2806508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D3F3B37-9A4C-EC26-582E-411E85430597}"/>
              </a:ext>
            </a:extLst>
          </p:cNvPr>
          <p:cNvSpPr txBox="1"/>
          <p:nvPr/>
        </p:nvSpPr>
        <p:spPr>
          <a:xfrm>
            <a:off x="1687248" y="2806508"/>
            <a:ext cx="3257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</a:t>
            </a:r>
            <a:endParaRPr lang="en-BE" sz="14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F45F918-8856-67E0-07C7-70B880D8F557}"/>
              </a:ext>
            </a:extLst>
          </p:cNvPr>
          <p:cNvSpPr txBox="1"/>
          <p:nvPr/>
        </p:nvSpPr>
        <p:spPr>
          <a:xfrm>
            <a:off x="2070305" y="2806508"/>
            <a:ext cx="2904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V</a:t>
            </a:r>
            <a:endParaRPr lang="en-BE" sz="14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65FF9AA-7C52-33E2-8F9C-19CBE7C08F38}"/>
              </a:ext>
            </a:extLst>
          </p:cNvPr>
          <p:cNvSpPr txBox="1"/>
          <p:nvPr/>
        </p:nvSpPr>
        <p:spPr>
          <a:xfrm>
            <a:off x="1305016" y="2186189"/>
            <a:ext cx="1261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Digested DNA</a:t>
            </a:r>
            <a:endParaRPr lang="en-BE" sz="1400" dirty="0"/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37CA94CD-991D-DBB5-29DB-00D0BED5F49A}"/>
              </a:ext>
            </a:extLst>
          </p:cNvPr>
          <p:cNvCxnSpPr>
            <a:cxnSpLocks/>
          </p:cNvCxnSpPr>
          <p:nvPr/>
        </p:nvCxnSpPr>
        <p:spPr>
          <a:xfrm>
            <a:off x="2086758" y="2803061"/>
            <a:ext cx="274011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1E57EE82-0D47-7253-2E80-7E6AC651D56B}"/>
              </a:ext>
            </a:extLst>
          </p:cNvPr>
          <p:cNvSpPr txBox="1"/>
          <p:nvPr/>
        </p:nvSpPr>
        <p:spPr>
          <a:xfrm>
            <a:off x="4364832" y="3593306"/>
            <a:ext cx="738663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S4: </a:t>
            </a:r>
            <a:r>
              <a:rPr lang="en-GB" dirty="0"/>
              <a:t>Controls for the CrPV vDNA detected in </a:t>
            </a:r>
            <a:r>
              <a:rPr lang="en-GB" i="1" dirty="0"/>
              <a:t>E. variegatus </a:t>
            </a:r>
            <a:r>
              <a:rPr lang="en-GB" dirty="0"/>
              <a:t>insects. Amplicons produced with CrPV-specific primers (CrPV_pair-1) from digested DNA, collected four (4 dpi) or nine (9 dpi) days after viral infection (V) or mock infection (M). The </a:t>
            </a:r>
            <a:r>
              <a:rPr lang="en-GB" dirty="0" err="1"/>
              <a:t>Thermo</a:t>
            </a:r>
            <a:r>
              <a:rPr lang="en-GB" dirty="0"/>
              <a:t> Fisher Scientific 1 </a:t>
            </a:r>
            <a:r>
              <a:rPr lang="en-GB" dirty="0" err="1"/>
              <a:t>Kb</a:t>
            </a:r>
            <a:r>
              <a:rPr lang="en-GB" dirty="0"/>
              <a:t> Plus DNA ladder was used as a reference.</a:t>
            </a:r>
            <a:endParaRPr lang="en-BE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D33CCA6-7B7E-170A-B1E9-F798E8761FE2}"/>
              </a:ext>
            </a:extLst>
          </p:cNvPr>
          <p:cNvSpPr txBox="1"/>
          <p:nvPr/>
        </p:nvSpPr>
        <p:spPr>
          <a:xfrm>
            <a:off x="1162642" y="5948601"/>
            <a:ext cx="1778400" cy="246221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CrPV_pair-1 (226 bp)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76E05412-5DB8-5BBB-0E6A-E4DC9F1E349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74704" r="9634" b="69152"/>
          <a:stretch>
            <a:fillRect/>
          </a:stretch>
        </p:blipFill>
        <p:spPr>
          <a:xfrm>
            <a:off x="1162966" y="3164084"/>
            <a:ext cx="1778076" cy="27347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28773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1C8CA942-6413-3FBC-3260-A3D3E3C26DD0}"/>
              </a:ext>
            </a:extLst>
          </p:cNvPr>
          <p:cNvGrpSpPr/>
          <p:nvPr/>
        </p:nvGrpSpPr>
        <p:grpSpPr>
          <a:xfrm>
            <a:off x="229848" y="63028"/>
            <a:ext cx="9718413" cy="335656"/>
            <a:chOff x="-94477" y="-313826"/>
            <a:chExt cx="9944388" cy="342848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EDED889-AD41-08EF-6198-FFC74948187F}"/>
                </a:ext>
              </a:extLst>
            </p:cNvPr>
            <p:cNvSpPr txBox="1"/>
            <p:nvPr/>
          </p:nvSpPr>
          <p:spPr>
            <a:xfrm>
              <a:off x="-94477" y="-309532"/>
              <a:ext cx="2977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A</a:t>
              </a:r>
              <a:endParaRPr lang="en-KN" sz="16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C0BB7D6-1EFA-ED23-5E9B-D33B3F49CF17}"/>
                </a:ext>
              </a:extLst>
            </p:cNvPr>
            <p:cNvSpPr txBox="1"/>
            <p:nvPr/>
          </p:nvSpPr>
          <p:spPr>
            <a:xfrm>
              <a:off x="5002906" y="-313826"/>
              <a:ext cx="2977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B</a:t>
              </a:r>
              <a:endParaRPr lang="en-KN" sz="1600" dirty="0"/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392B0A6-20D4-B931-2B52-DCCCD05DA4C8}"/>
                </a:ext>
              </a:extLst>
            </p:cNvPr>
            <p:cNvSpPr txBox="1"/>
            <p:nvPr/>
          </p:nvSpPr>
          <p:spPr>
            <a:xfrm>
              <a:off x="9552199" y="-309579"/>
              <a:ext cx="29771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C</a:t>
              </a:r>
              <a:endParaRPr lang="en-KN" sz="1600" dirty="0"/>
            </a:p>
          </p:txBody>
        </p:sp>
      </p:grp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FDF92158-05A6-DA03-3CFA-FA43D580E8C9}"/>
              </a:ext>
            </a:extLst>
          </p:cNvPr>
          <p:cNvCxnSpPr/>
          <p:nvPr/>
        </p:nvCxnSpPr>
        <p:spPr>
          <a:xfrm>
            <a:off x="445759" y="644435"/>
            <a:ext cx="3220550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66BD3CE8-9D6F-1ADD-83AE-C3090883AC40}"/>
              </a:ext>
            </a:extLst>
          </p:cNvPr>
          <p:cNvSpPr txBox="1"/>
          <p:nvPr/>
        </p:nvSpPr>
        <p:spPr>
          <a:xfrm>
            <a:off x="1654739" y="280408"/>
            <a:ext cx="80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BmN4</a:t>
            </a:r>
            <a:endParaRPr lang="en-BE" dirty="0"/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4FBC7381-D7E8-F850-B291-C68BF235DDAA}"/>
              </a:ext>
            </a:extLst>
          </p:cNvPr>
          <p:cNvCxnSpPr>
            <a:cxnSpLocks/>
          </p:cNvCxnSpPr>
          <p:nvPr/>
        </p:nvCxnSpPr>
        <p:spPr>
          <a:xfrm>
            <a:off x="5487202" y="644435"/>
            <a:ext cx="2985373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FF5CAB9C-5CB0-9BCB-1EBD-6C067BF4AB3A}"/>
              </a:ext>
            </a:extLst>
          </p:cNvPr>
          <p:cNvSpPr txBox="1"/>
          <p:nvPr/>
        </p:nvSpPr>
        <p:spPr>
          <a:xfrm>
            <a:off x="6462057" y="289230"/>
            <a:ext cx="10846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High Five</a:t>
            </a:r>
            <a:endParaRPr lang="en-BE" dirty="0"/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DBFC46DD-6B45-0738-FAA3-AE96AAA4F691}"/>
              </a:ext>
            </a:extLst>
          </p:cNvPr>
          <p:cNvCxnSpPr>
            <a:cxnSpLocks/>
          </p:cNvCxnSpPr>
          <p:nvPr/>
        </p:nvCxnSpPr>
        <p:spPr>
          <a:xfrm>
            <a:off x="9948261" y="629642"/>
            <a:ext cx="864723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48FE1A9E-70C6-DE4C-E315-E92EE2C0C6A6}"/>
              </a:ext>
            </a:extLst>
          </p:cNvPr>
          <p:cNvSpPr txBox="1"/>
          <p:nvPr/>
        </p:nvSpPr>
        <p:spPr>
          <a:xfrm>
            <a:off x="9848160" y="272153"/>
            <a:ext cx="10846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High Five</a:t>
            </a:r>
            <a:endParaRPr lang="en-BE" dirty="0"/>
          </a:p>
        </p:txBody>
      </p:sp>
      <p:sp>
        <p:nvSpPr>
          <p:cNvPr id="60" name="Rectangle 4">
            <a:extLst>
              <a:ext uri="{FF2B5EF4-FFF2-40B4-BE49-F238E27FC236}">
                <a16:creationId xmlns:a16="http://schemas.microsoft.com/office/drawing/2014/main" id="{40BFFB98-8057-D97A-031A-04EBDED5C5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5980" y="4913320"/>
            <a:ext cx="10176393" cy="18774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i="0" u="none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Figure S5:</a:t>
            </a:r>
            <a:r>
              <a:rPr kumimoji="0" lang="en-US" altLang="ja-JP" sz="1400" b="0" i="0" u="none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ja-JP" sz="1400" b="0" i="0" u="none" strike="noStrike" cap="none" normalizeH="0" baseline="0" dirty="0" err="1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vDNA</a:t>
            </a:r>
            <a:r>
              <a:rPr kumimoji="0" lang="en-US" altLang="ja-JP" sz="1400" b="0" i="0" u="none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from persistently present non-RT RNA viruses in lepidopteran cell lines. </a:t>
            </a:r>
            <a:r>
              <a:rPr kumimoji="0" lang="en-US" altLang="ja-JP" sz="1400" b="1" i="0" u="none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A:</a:t>
            </a:r>
            <a:r>
              <a:rPr kumimoji="0" lang="en-US" altLang="ja-JP" sz="1400" b="0" i="0" u="none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Amplicons produced by PCR with </a:t>
            </a:r>
            <a:r>
              <a:rPr kumimoji="0" lang="en-US" altLang="ja-JP" sz="1400" b="0" i="0" u="none" strike="noStrike" cap="none" normalizeH="0" baseline="0" dirty="0" err="1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BmLV</a:t>
            </a:r>
            <a:r>
              <a:rPr kumimoji="0" lang="en-US" altLang="ja-JP" sz="1400" b="0" i="0" u="none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-specific primers from DNA </a:t>
            </a:r>
            <a:r>
              <a:rPr kumimoji="0" lang="en-GB" altLang="ja-JP" sz="1400" b="0" i="0" u="none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extracted </a:t>
            </a:r>
            <a:r>
              <a:rPr kumimoji="0" lang="en-US" altLang="ja-JP" sz="1400" b="0" i="0" u="none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from </a:t>
            </a:r>
            <a:r>
              <a:rPr kumimoji="0" lang="en-US" altLang="ja-JP" sz="1400" b="0" i="1" u="none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B. mori</a:t>
            </a:r>
            <a:r>
              <a:rPr kumimoji="0" lang="en-US" altLang="ja-JP" sz="1400" b="0" i="0" u="none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BmN4 cells persistently infected with </a:t>
            </a:r>
            <a:r>
              <a:rPr kumimoji="0" lang="en-US" altLang="ja-JP" sz="1400" b="0" i="0" u="none" strike="noStrike" cap="none" normalizeH="0" baseline="0" dirty="0" err="1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BmLV</a:t>
            </a:r>
            <a:r>
              <a:rPr kumimoji="0" lang="en-US" altLang="ja-JP" sz="1400" b="0" i="0" u="none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. Left to right, MLV_pair-1-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9</a:t>
            </a:r>
            <a:r>
              <a:rPr kumimoji="0" lang="en-US" altLang="ja-JP" sz="1400" b="0" i="0" u="none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were used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, as indicated. </a:t>
            </a: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B: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Amplicons produced with </a:t>
            </a:r>
            <a:r>
              <a:rPr kumimoji="0" lang="en-US" altLang="ja-JP" sz="1400" b="0" i="0" strike="noStrike" cap="none" normalizeH="0" baseline="0" dirty="0" err="1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BmLV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-specific primers from DNA from </a:t>
            </a:r>
            <a:r>
              <a:rPr kumimoji="0" lang="en-US" altLang="ja-JP" sz="1400" b="0" i="1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kumimoji="0" lang="en-US" altLang="ja-JP" sz="1400" b="0" i="1" strike="noStrike" cap="none" normalizeH="0" baseline="0" dirty="0" err="1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ni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High Five cells persistently infected with </a:t>
            </a:r>
            <a:r>
              <a:rPr kumimoji="0" lang="en-US" altLang="ja-JP" sz="1400" b="0" i="0" strike="noStrike" cap="none" normalizeH="0" baseline="0" dirty="0" err="1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BmLV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and FHV. Left to right, MLV_pair-1-9 were used, as indicated. </a:t>
            </a:r>
            <a:r>
              <a:rPr kumimoji="0" lang="en-US" altLang="ja-JP" sz="1400" b="1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: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Amplicons produced with FHV-specific primers from DNA from </a:t>
            </a:r>
            <a:r>
              <a:rPr kumimoji="0" lang="en-US" altLang="ja-JP" sz="1400" b="0" i="1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kumimoji="0" lang="en-US" altLang="ja-JP" sz="1400" b="0" i="1" strike="noStrike" cap="none" normalizeH="0" baseline="0" dirty="0" err="1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ni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High Five cells persistently infected with </a:t>
            </a:r>
            <a:r>
              <a:rPr kumimoji="0" lang="en-US" altLang="ja-JP" sz="1400" b="0" i="0" strike="noStrike" cap="none" normalizeH="0" baseline="0" dirty="0" err="1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BmLV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and FHV. Left to right, FHV_pair-1-2 were used, as indicated. The </a:t>
            </a:r>
            <a:r>
              <a:rPr kumimoji="0" lang="en-US" altLang="ja-JP" sz="1400" b="0" i="0" strike="noStrike" cap="none" normalizeH="0" baseline="0" dirty="0" err="1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Thermo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Fisher Scientific 1 </a:t>
            </a:r>
            <a:r>
              <a:rPr kumimoji="0" lang="en-US" altLang="ja-JP" sz="1400" b="0" i="0" strike="noStrike" cap="none" normalizeH="0" baseline="0" dirty="0" err="1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Kb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Plus DNA Ladder was used as a reference for panels S5 A and S5 B, while the </a:t>
            </a:r>
            <a:r>
              <a:rPr kumimoji="0" lang="en-US" altLang="ja-JP" sz="1400" b="0" i="0" strike="noStrike" cap="none" normalizeH="0" baseline="0" dirty="0" err="1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Thermo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Fisher Scientific </a:t>
            </a:r>
            <a:r>
              <a:rPr kumimoji="0" lang="en-US" altLang="ja-JP" sz="1400" b="0" i="0" strike="noStrike" cap="none" normalizeH="0" baseline="0" dirty="0" err="1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O’Range</a:t>
            </a:r>
            <a:r>
              <a:rPr kumimoji="0" lang="en-US" altLang="ja-JP" sz="1400" b="0" i="0" strike="noStrike" cap="none" normalizeH="0" baseline="0" dirty="0">
                <a:ln>
                  <a:noFill/>
                </a:ln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Ruler 200 bp DNA Ladder was used as a reference for panel S5 C.</a:t>
            </a:r>
            <a:endParaRPr kumimoji="0" lang="en-US" altLang="ja-JP" sz="1400" b="0" i="0" strike="noStrike" cap="none" normalizeH="0" baseline="0" dirty="0">
              <a:ln>
                <a:noFill/>
              </a:ln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C5966692-2E7B-A5CE-AC40-AA345F4B82D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286" t="58781" r="53714" b="12127"/>
          <a:stretch>
            <a:fillRect/>
          </a:stretch>
        </p:blipFill>
        <p:spPr>
          <a:xfrm rot="5400000">
            <a:off x="-812951" y="1711555"/>
            <a:ext cx="3931909" cy="1995136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6354191B-1596-1E9A-D795-CC458D99FDB5}"/>
              </a:ext>
            </a:extLst>
          </p:cNvPr>
          <p:cNvSpPr txBox="1"/>
          <p:nvPr/>
        </p:nvSpPr>
        <p:spPr>
          <a:xfrm>
            <a:off x="229849" y="4058324"/>
            <a:ext cx="1702462" cy="246221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MLV_pair-1-9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71DABC7E-5032-10CC-0247-F7F96A9C3A9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750" t="23307" r="53269" b="46627"/>
          <a:stretch>
            <a:fillRect/>
          </a:stretch>
        </p:blipFill>
        <p:spPr>
          <a:xfrm rot="5400000">
            <a:off x="1236664" y="1679025"/>
            <a:ext cx="3930172" cy="2061931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9562EA1F-861D-A43D-7E64-EC62BA51E8FD}"/>
              </a:ext>
            </a:extLst>
          </p:cNvPr>
          <p:cNvSpPr txBox="1"/>
          <p:nvPr/>
        </p:nvSpPr>
        <p:spPr>
          <a:xfrm>
            <a:off x="229848" y="4358756"/>
            <a:ext cx="3685295" cy="246868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 rtlCol="0">
            <a:spAutoFit/>
          </a:bodyPr>
          <a:lstStyle/>
          <a:p>
            <a:pPr algn="ctr"/>
            <a:endParaRPr lang="en-US" sz="10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B2FDD9B-E01F-CD0B-7395-254E8ACABB34}"/>
              </a:ext>
            </a:extLst>
          </p:cNvPr>
          <p:cNvSpPr txBox="1"/>
          <p:nvPr/>
        </p:nvSpPr>
        <p:spPr>
          <a:xfrm>
            <a:off x="313772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</a:t>
            </a:r>
            <a:endParaRPr lang="en-BE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D59139D-D438-30C3-1854-E9F8867CEFEC}"/>
              </a:ext>
            </a:extLst>
          </p:cNvPr>
          <p:cNvSpPr txBox="1"/>
          <p:nvPr/>
        </p:nvSpPr>
        <p:spPr>
          <a:xfrm>
            <a:off x="698792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</a:t>
            </a:r>
            <a:endParaRPr lang="en-BE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0588FF8-A057-9CCA-074B-2DB7496F445E}"/>
              </a:ext>
            </a:extLst>
          </p:cNvPr>
          <p:cNvSpPr txBox="1"/>
          <p:nvPr/>
        </p:nvSpPr>
        <p:spPr>
          <a:xfrm>
            <a:off x="1046930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3</a:t>
            </a:r>
            <a:endParaRPr lang="en-BE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BC0134E-5ACF-EAD1-D9D9-7FE3B85B3821}"/>
              </a:ext>
            </a:extLst>
          </p:cNvPr>
          <p:cNvSpPr txBox="1"/>
          <p:nvPr/>
        </p:nvSpPr>
        <p:spPr>
          <a:xfrm>
            <a:off x="1400738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4</a:t>
            </a:r>
            <a:endParaRPr lang="en-BE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E41A0D3-3212-F18F-58C0-01D5973E64B4}"/>
              </a:ext>
            </a:extLst>
          </p:cNvPr>
          <p:cNvSpPr txBox="1"/>
          <p:nvPr/>
        </p:nvSpPr>
        <p:spPr>
          <a:xfrm>
            <a:off x="1747996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5</a:t>
            </a:r>
            <a:endParaRPr lang="en-BE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68F6CAA-C492-36CB-7D6B-03E59F300256}"/>
              </a:ext>
            </a:extLst>
          </p:cNvPr>
          <p:cNvSpPr txBox="1"/>
          <p:nvPr/>
        </p:nvSpPr>
        <p:spPr>
          <a:xfrm>
            <a:off x="2267229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6</a:t>
            </a:r>
            <a:endParaRPr lang="en-BE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FE8EC53-CE8C-C726-63EA-D78730383343}"/>
              </a:ext>
            </a:extLst>
          </p:cNvPr>
          <p:cNvSpPr txBox="1"/>
          <p:nvPr/>
        </p:nvSpPr>
        <p:spPr>
          <a:xfrm>
            <a:off x="2677748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7</a:t>
            </a:r>
            <a:endParaRPr lang="en-BE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26EC121-EA52-1620-9470-23B802A1C84E}"/>
              </a:ext>
            </a:extLst>
          </p:cNvPr>
          <p:cNvSpPr txBox="1"/>
          <p:nvPr/>
        </p:nvSpPr>
        <p:spPr>
          <a:xfrm>
            <a:off x="3047373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8</a:t>
            </a:r>
            <a:endParaRPr lang="en-BE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346FB7F-9608-7213-DF23-9917FDCA27FB}"/>
              </a:ext>
            </a:extLst>
          </p:cNvPr>
          <p:cNvSpPr txBox="1"/>
          <p:nvPr/>
        </p:nvSpPr>
        <p:spPr>
          <a:xfrm>
            <a:off x="3428273" y="4320538"/>
            <a:ext cx="3947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9</a:t>
            </a:r>
            <a:endParaRPr lang="en-BE" dirty="0"/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2F98DD23-699F-B5EC-E626-1E579D8D3DB5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52140" t="-3135" r="28685" b="38677"/>
          <a:stretch>
            <a:fillRect/>
          </a:stretch>
        </p:blipFill>
        <p:spPr>
          <a:xfrm>
            <a:off x="5345342" y="540288"/>
            <a:ext cx="1636761" cy="4126568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94EA847C-9DE1-842C-E494-2DB4DA2BEB4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74945" t="153" r="5122" b="39683"/>
          <a:stretch>
            <a:fillRect/>
          </a:stretch>
        </p:blipFill>
        <p:spPr>
          <a:xfrm>
            <a:off x="7024767" y="734995"/>
            <a:ext cx="1736912" cy="3931862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78527714-099E-D26C-958B-8A2BE99435E1}"/>
              </a:ext>
            </a:extLst>
          </p:cNvPr>
          <p:cNvSpPr txBox="1"/>
          <p:nvPr/>
        </p:nvSpPr>
        <p:spPr>
          <a:xfrm>
            <a:off x="5445871" y="4058324"/>
            <a:ext cx="1702462" cy="246221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MLV_pair-1-9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5EFE52E-7CFD-32F4-5516-717EE7983AE9}"/>
              </a:ext>
            </a:extLst>
          </p:cNvPr>
          <p:cNvSpPr txBox="1"/>
          <p:nvPr/>
        </p:nvSpPr>
        <p:spPr>
          <a:xfrm>
            <a:off x="5445871" y="4359402"/>
            <a:ext cx="3164584" cy="246221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 rtlCol="0">
            <a:spAutoFit/>
          </a:bodyPr>
          <a:lstStyle/>
          <a:p>
            <a:pPr algn="ctr"/>
            <a:endParaRPr lang="en-US" sz="10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84FB2ED-CFF3-95BF-D686-551459BDC878}"/>
              </a:ext>
            </a:extLst>
          </p:cNvPr>
          <p:cNvSpPr txBox="1"/>
          <p:nvPr/>
        </p:nvSpPr>
        <p:spPr>
          <a:xfrm>
            <a:off x="5451720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</a:t>
            </a:r>
            <a:endParaRPr lang="en-BE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9288AFF-2F39-1382-3845-B193864EDDDC}"/>
              </a:ext>
            </a:extLst>
          </p:cNvPr>
          <p:cNvSpPr txBox="1"/>
          <p:nvPr/>
        </p:nvSpPr>
        <p:spPr>
          <a:xfrm>
            <a:off x="5749449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</a:t>
            </a:r>
            <a:endParaRPr lang="en-BE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23398F5-88B2-CDB3-8640-88FB7A40F5AE}"/>
              </a:ext>
            </a:extLst>
          </p:cNvPr>
          <p:cNvSpPr txBox="1"/>
          <p:nvPr/>
        </p:nvSpPr>
        <p:spPr>
          <a:xfrm>
            <a:off x="6063329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3</a:t>
            </a:r>
            <a:endParaRPr lang="en-BE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6E1373E-2635-6335-A3A3-20569DD05438}"/>
              </a:ext>
            </a:extLst>
          </p:cNvPr>
          <p:cNvSpPr txBox="1"/>
          <p:nvPr/>
        </p:nvSpPr>
        <p:spPr>
          <a:xfrm>
            <a:off x="6389264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4</a:t>
            </a:r>
            <a:endParaRPr lang="en-BE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5652482-CF1A-F60B-2D7B-6BB68DD5F269}"/>
              </a:ext>
            </a:extLst>
          </p:cNvPr>
          <p:cNvSpPr txBox="1"/>
          <p:nvPr/>
        </p:nvSpPr>
        <p:spPr>
          <a:xfrm>
            <a:off x="6649234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5</a:t>
            </a:r>
            <a:endParaRPr lang="en-BE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9F8CA53-2B8A-F1C5-53C9-7333F415CC86}"/>
              </a:ext>
            </a:extLst>
          </p:cNvPr>
          <p:cNvSpPr txBox="1"/>
          <p:nvPr/>
        </p:nvSpPr>
        <p:spPr>
          <a:xfrm>
            <a:off x="7031691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6</a:t>
            </a:r>
            <a:endParaRPr lang="en-BE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12F980B-4387-9A28-5D97-ED50795781B4}"/>
              </a:ext>
            </a:extLst>
          </p:cNvPr>
          <p:cNvSpPr txBox="1"/>
          <p:nvPr/>
        </p:nvSpPr>
        <p:spPr>
          <a:xfrm>
            <a:off x="7391030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7</a:t>
            </a:r>
            <a:endParaRPr lang="en-BE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263A692-F72F-F416-91C6-1074F7FCA12D}"/>
              </a:ext>
            </a:extLst>
          </p:cNvPr>
          <p:cNvSpPr txBox="1"/>
          <p:nvPr/>
        </p:nvSpPr>
        <p:spPr>
          <a:xfrm>
            <a:off x="7711687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8</a:t>
            </a:r>
            <a:endParaRPr lang="en-BE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8E31BF4-199F-7052-75D4-21DDF6F62186}"/>
              </a:ext>
            </a:extLst>
          </p:cNvPr>
          <p:cNvSpPr txBox="1"/>
          <p:nvPr/>
        </p:nvSpPr>
        <p:spPr>
          <a:xfrm>
            <a:off x="8062597" y="4320538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9</a:t>
            </a:r>
            <a:endParaRPr lang="en-BE" dirty="0"/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B1485FDF-40B9-E9AE-71ED-0840A6BC6654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5106" t="14483" r="73427" b="41184"/>
          <a:stretch>
            <a:fillRect/>
          </a:stretch>
        </p:blipFill>
        <p:spPr>
          <a:xfrm>
            <a:off x="9904353" y="728376"/>
            <a:ext cx="1353133" cy="3923687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1FB50069-68F6-0124-99A6-687D5AA13877}"/>
              </a:ext>
            </a:extLst>
          </p:cNvPr>
          <p:cNvSpPr txBox="1"/>
          <p:nvPr/>
        </p:nvSpPr>
        <p:spPr>
          <a:xfrm>
            <a:off x="9995227" y="4036510"/>
            <a:ext cx="1171387" cy="246221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FHV_pair-1-2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61D1041E-DF91-4D77-36D5-A2DA7E3C7FA4}"/>
              </a:ext>
            </a:extLst>
          </p:cNvPr>
          <p:cNvSpPr txBox="1"/>
          <p:nvPr/>
        </p:nvSpPr>
        <p:spPr>
          <a:xfrm>
            <a:off x="9995227" y="4343962"/>
            <a:ext cx="937589" cy="247515"/>
          </a:xfrm>
          <a:prstGeom prst="rect">
            <a:avLst/>
          </a:prstGeom>
          <a:solidFill>
            <a:schemeClr val="bg2">
              <a:lumMod val="90000"/>
            </a:schemeClr>
          </a:solidFill>
        </p:spPr>
        <p:txBody>
          <a:bodyPr wrap="square" rtlCol="0">
            <a:spAutoFit/>
          </a:bodyPr>
          <a:lstStyle/>
          <a:p>
            <a:pPr algn="ctr"/>
            <a:endParaRPr lang="en-US" sz="10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B8D0FC0-9827-E355-E644-CF6A7526C3B7}"/>
              </a:ext>
            </a:extLst>
          </p:cNvPr>
          <p:cNvSpPr txBox="1"/>
          <p:nvPr/>
        </p:nvSpPr>
        <p:spPr>
          <a:xfrm>
            <a:off x="10022218" y="4305745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1</a:t>
            </a:r>
            <a:endParaRPr lang="en-BE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69376FF-07A1-A8C9-DEF9-F21A47F06F2B}"/>
              </a:ext>
            </a:extLst>
          </p:cNvPr>
          <p:cNvSpPr txBox="1"/>
          <p:nvPr/>
        </p:nvSpPr>
        <p:spPr>
          <a:xfrm>
            <a:off x="10412643" y="4305745"/>
            <a:ext cx="3010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</a:t>
            </a:r>
            <a:endParaRPr lang="en-BE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5133E60-633C-7572-AAE4-946AEEE6DA32}"/>
              </a:ext>
            </a:extLst>
          </p:cNvPr>
          <p:cNvSpPr txBox="1"/>
          <p:nvPr/>
        </p:nvSpPr>
        <p:spPr>
          <a:xfrm>
            <a:off x="4170452" y="3544354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100 bp</a:t>
            </a:r>
            <a:endParaRPr lang="en-BE" sz="9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3DFCA47-DD02-335D-E018-025B28613E86}"/>
              </a:ext>
            </a:extLst>
          </p:cNvPr>
          <p:cNvSpPr txBox="1"/>
          <p:nvPr/>
        </p:nvSpPr>
        <p:spPr>
          <a:xfrm>
            <a:off x="4170452" y="3221229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200 bp</a:t>
            </a:r>
            <a:endParaRPr lang="en-BE" sz="9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D5943D5-CF91-1382-2D58-ADE79AE81200}"/>
              </a:ext>
            </a:extLst>
          </p:cNvPr>
          <p:cNvSpPr txBox="1"/>
          <p:nvPr/>
        </p:nvSpPr>
        <p:spPr>
          <a:xfrm>
            <a:off x="4170452" y="2990397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300 bp</a:t>
            </a:r>
            <a:endParaRPr lang="en-BE" sz="9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438A98-5BC3-6EF5-672D-295D17DB5B9E}"/>
              </a:ext>
            </a:extLst>
          </p:cNvPr>
          <p:cNvSpPr txBox="1"/>
          <p:nvPr/>
        </p:nvSpPr>
        <p:spPr>
          <a:xfrm>
            <a:off x="4170452" y="2824811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400 bp</a:t>
            </a:r>
            <a:endParaRPr lang="en-BE" sz="9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51D78E8-95E6-312F-14F4-FC427380E794}"/>
              </a:ext>
            </a:extLst>
          </p:cNvPr>
          <p:cNvSpPr txBox="1"/>
          <p:nvPr/>
        </p:nvSpPr>
        <p:spPr>
          <a:xfrm>
            <a:off x="4170452" y="2697589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500 bp</a:t>
            </a:r>
            <a:endParaRPr lang="en-BE" sz="9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5EDB9E8-2E35-D4E5-D06B-E5C1046931F0}"/>
              </a:ext>
            </a:extLst>
          </p:cNvPr>
          <p:cNvSpPr txBox="1"/>
          <p:nvPr/>
        </p:nvSpPr>
        <p:spPr>
          <a:xfrm>
            <a:off x="4170452" y="2569687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650 bp</a:t>
            </a:r>
            <a:endParaRPr lang="en-BE" sz="9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4844728-E717-E0D3-9DDB-842C3A770BF3}"/>
              </a:ext>
            </a:extLst>
          </p:cNvPr>
          <p:cNvSpPr txBox="1"/>
          <p:nvPr/>
        </p:nvSpPr>
        <p:spPr>
          <a:xfrm>
            <a:off x="4170452" y="2416523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850 bp</a:t>
            </a:r>
            <a:endParaRPr lang="en-BE" sz="9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35A5C0B-1414-3EC4-947A-9E59A59E7949}"/>
              </a:ext>
            </a:extLst>
          </p:cNvPr>
          <p:cNvSpPr txBox="1"/>
          <p:nvPr/>
        </p:nvSpPr>
        <p:spPr>
          <a:xfrm>
            <a:off x="4170452" y="2321323"/>
            <a:ext cx="5806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1000 bp</a:t>
            </a:r>
            <a:endParaRPr lang="en-BE" sz="9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2688800-4E86-49BF-8893-48337038FF73}"/>
              </a:ext>
            </a:extLst>
          </p:cNvPr>
          <p:cNvSpPr txBox="1"/>
          <p:nvPr/>
        </p:nvSpPr>
        <p:spPr>
          <a:xfrm>
            <a:off x="4170452" y="2120792"/>
            <a:ext cx="5806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1500 bp</a:t>
            </a:r>
            <a:endParaRPr lang="en-BE" sz="9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70BD4C7-E631-23F7-84BE-CF7B5DF15A3E}"/>
              </a:ext>
            </a:extLst>
          </p:cNvPr>
          <p:cNvSpPr txBox="1"/>
          <p:nvPr/>
        </p:nvSpPr>
        <p:spPr>
          <a:xfrm>
            <a:off x="8761679" y="3452061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100 bp</a:t>
            </a:r>
            <a:endParaRPr lang="en-BE" sz="9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C78A118-BEF0-0F1F-0CE9-981BBB81D47C}"/>
              </a:ext>
            </a:extLst>
          </p:cNvPr>
          <p:cNvSpPr txBox="1"/>
          <p:nvPr/>
        </p:nvSpPr>
        <p:spPr>
          <a:xfrm>
            <a:off x="8761679" y="3182092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200 bp</a:t>
            </a:r>
            <a:endParaRPr lang="en-BE" sz="9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9287BB0-588B-3225-4699-1DE34B502999}"/>
              </a:ext>
            </a:extLst>
          </p:cNvPr>
          <p:cNvSpPr txBox="1"/>
          <p:nvPr/>
        </p:nvSpPr>
        <p:spPr>
          <a:xfrm>
            <a:off x="8761679" y="2997777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300 bp</a:t>
            </a:r>
            <a:endParaRPr lang="en-BE" sz="9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6701F8BF-681A-7189-3874-863244ED6492}"/>
              </a:ext>
            </a:extLst>
          </p:cNvPr>
          <p:cNvSpPr txBox="1"/>
          <p:nvPr/>
        </p:nvSpPr>
        <p:spPr>
          <a:xfrm>
            <a:off x="8761679" y="2912123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400 bp</a:t>
            </a:r>
            <a:endParaRPr lang="en-BE" sz="9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D78ADBC-DC58-6995-EDE1-1545BE2489A6}"/>
              </a:ext>
            </a:extLst>
          </p:cNvPr>
          <p:cNvSpPr txBox="1"/>
          <p:nvPr/>
        </p:nvSpPr>
        <p:spPr>
          <a:xfrm>
            <a:off x="8761679" y="2793473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500 bp</a:t>
            </a:r>
            <a:endParaRPr lang="en-BE" sz="9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BBA46FA1-1A42-A3A2-519C-CB7660CF4AAB}"/>
              </a:ext>
            </a:extLst>
          </p:cNvPr>
          <p:cNvSpPr txBox="1"/>
          <p:nvPr/>
        </p:nvSpPr>
        <p:spPr>
          <a:xfrm>
            <a:off x="8761679" y="2703305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650 bp</a:t>
            </a:r>
            <a:endParaRPr lang="en-BE" sz="9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D9FCCC5-A49C-8BB0-9586-E75C6310D7A4}"/>
              </a:ext>
            </a:extLst>
          </p:cNvPr>
          <p:cNvSpPr txBox="1"/>
          <p:nvPr/>
        </p:nvSpPr>
        <p:spPr>
          <a:xfrm>
            <a:off x="8761679" y="2574720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850 bp</a:t>
            </a:r>
            <a:endParaRPr lang="en-BE" sz="9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0B4566B-1B2C-2E28-585E-C86A9F95B5D1}"/>
              </a:ext>
            </a:extLst>
          </p:cNvPr>
          <p:cNvSpPr txBox="1"/>
          <p:nvPr/>
        </p:nvSpPr>
        <p:spPr>
          <a:xfrm>
            <a:off x="8761679" y="2464993"/>
            <a:ext cx="5806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1000 bp</a:t>
            </a:r>
            <a:endParaRPr lang="en-BE" sz="9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BE7C7F3-9DE7-2BFB-90A2-D8DBC843C533}"/>
              </a:ext>
            </a:extLst>
          </p:cNvPr>
          <p:cNvSpPr txBox="1"/>
          <p:nvPr/>
        </p:nvSpPr>
        <p:spPr>
          <a:xfrm>
            <a:off x="8761679" y="2232768"/>
            <a:ext cx="5806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1500 bp</a:t>
            </a:r>
            <a:endParaRPr lang="en-BE" sz="9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8875BAA-0515-1579-6AF1-015C26688314}"/>
              </a:ext>
            </a:extLst>
          </p:cNvPr>
          <p:cNvSpPr txBox="1"/>
          <p:nvPr/>
        </p:nvSpPr>
        <p:spPr>
          <a:xfrm>
            <a:off x="11234532" y="3775186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200 bp</a:t>
            </a:r>
            <a:endParaRPr lang="en-BE" sz="900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72369EB-8721-7151-BF88-5B69C8C5D78A}"/>
              </a:ext>
            </a:extLst>
          </p:cNvPr>
          <p:cNvSpPr txBox="1"/>
          <p:nvPr/>
        </p:nvSpPr>
        <p:spPr>
          <a:xfrm>
            <a:off x="11234532" y="3428938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400 bp</a:t>
            </a:r>
            <a:endParaRPr lang="en-BE" sz="9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0606E66-53A0-256D-3A60-D1FC4D630EAC}"/>
              </a:ext>
            </a:extLst>
          </p:cNvPr>
          <p:cNvSpPr txBox="1"/>
          <p:nvPr/>
        </p:nvSpPr>
        <p:spPr>
          <a:xfrm>
            <a:off x="11234532" y="3214571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600 bp</a:t>
            </a:r>
            <a:endParaRPr lang="en-BE" sz="9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D438BD68-A75B-78B5-B693-57AEC62F97C6}"/>
              </a:ext>
            </a:extLst>
          </p:cNvPr>
          <p:cNvSpPr txBox="1"/>
          <p:nvPr/>
        </p:nvSpPr>
        <p:spPr>
          <a:xfrm>
            <a:off x="11234532" y="3048481"/>
            <a:ext cx="5196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800 bp</a:t>
            </a:r>
            <a:endParaRPr lang="en-BE" sz="9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B8D67D0-34BF-09E3-52D8-E1D09A64A0AA}"/>
              </a:ext>
            </a:extLst>
          </p:cNvPr>
          <p:cNvSpPr txBox="1"/>
          <p:nvPr/>
        </p:nvSpPr>
        <p:spPr>
          <a:xfrm>
            <a:off x="11234532" y="2912123"/>
            <a:ext cx="5806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/>
              <a:t>1000 bp</a:t>
            </a:r>
            <a:endParaRPr lang="en-BE" sz="900" dirty="0"/>
          </a:p>
        </p:txBody>
      </p:sp>
    </p:spTree>
    <p:extLst>
      <p:ext uri="{BB962C8B-B14F-4D97-AF65-F5344CB8AC3E}">
        <p14:creationId xmlns:p14="http://schemas.microsoft.com/office/powerpoint/2010/main" val="19908159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B03DC8D-4D30-C94B-5858-67DEBA8CAF00}"/>
              </a:ext>
            </a:extLst>
          </p:cNvPr>
          <p:cNvGrpSpPr/>
          <p:nvPr/>
        </p:nvGrpSpPr>
        <p:grpSpPr>
          <a:xfrm>
            <a:off x="1013380" y="2401657"/>
            <a:ext cx="5311325" cy="2720758"/>
            <a:chOff x="571500" y="1877703"/>
            <a:chExt cx="3095625" cy="1913247"/>
          </a:xfrm>
        </p:grpSpPr>
        <p:pic>
          <p:nvPicPr>
            <p:cNvPr id="3" name="Image1">
              <a:extLst>
                <a:ext uri="{FF2B5EF4-FFF2-40B4-BE49-F238E27FC236}">
                  <a16:creationId xmlns:a16="http://schemas.microsoft.com/office/drawing/2014/main" id="{0095EED3-86D9-5A11-6161-CFC1896AB4F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18215" t="44857" r="29348" b="12094"/>
            <a:stretch>
              <a:fillRect/>
            </a:stretch>
          </p:blipFill>
          <p:spPr bwMode="auto">
            <a:xfrm>
              <a:off x="571500" y="1877703"/>
              <a:ext cx="3095625" cy="1913247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32A17152-A9B6-EE89-6B37-89040A538563}"/>
                </a:ext>
              </a:extLst>
            </p:cNvPr>
            <p:cNvSpPr txBox="1"/>
            <p:nvPr/>
          </p:nvSpPr>
          <p:spPr>
            <a:xfrm>
              <a:off x="794336" y="3446650"/>
              <a:ext cx="2703611" cy="259716"/>
            </a:xfrm>
            <a:prstGeom prst="rect">
              <a:avLst/>
            </a:prstGeom>
            <a:solidFill>
              <a:schemeClr val="bg2">
                <a:lumMod val="90000"/>
              </a:schemeClr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dirty="0"/>
                <a:t>Actin (189 bp)</a:t>
              </a:r>
              <a:endParaRPr lang="en-KN" sz="1000" dirty="0">
                <a:solidFill>
                  <a:srgbClr val="FF0000"/>
                </a:solidFill>
              </a:endParaRP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E42CDF38-D2E7-1C5B-53F8-F2575D53937B}"/>
              </a:ext>
            </a:extLst>
          </p:cNvPr>
          <p:cNvSpPr txBox="1"/>
          <p:nvPr/>
        </p:nvSpPr>
        <p:spPr>
          <a:xfrm>
            <a:off x="572839" y="4400032"/>
            <a:ext cx="608493" cy="232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100 bp</a:t>
            </a:r>
            <a:endParaRPr lang="en-BE" sz="9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68D3B9B-4433-0EA2-F1CB-C6C2A1E6A17D}"/>
              </a:ext>
            </a:extLst>
          </p:cNvPr>
          <p:cNvSpPr txBox="1"/>
          <p:nvPr/>
        </p:nvSpPr>
        <p:spPr>
          <a:xfrm>
            <a:off x="572839" y="4121758"/>
            <a:ext cx="608493" cy="232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200 bp</a:t>
            </a:r>
            <a:endParaRPr lang="en-BE" sz="9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73F504E-D218-E518-CD77-0B64EB9B000E}"/>
              </a:ext>
            </a:extLst>
          </p:cNvPr>
          <p:cNvSpPr txBox="1"/>
          <p:nvPr/>
        </p:nvSpPr>
        <p:spPr>
          <a:xfrm>
            <a:off x="572839" y="3928115"/>
            <a:ext cx="608493" cy="232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300 bp</a:t>
            </a:r>
            <a:endParaRPr lang="en-BE" sz="9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49DCC23-D240-5841-47D4-635204E61852}"/>
              </a:ext>
            </a:extLst>
          </p:cNvPr>
          <p:cNvSpPr txBox="1"/>
          <p:nvPr/>
        </p:nvSpPr>
        <p:spPr>
          <a:xfrm>
            <a:off x="572839" y="3766224"/>
            <a:ext cx="608493" cy="232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400 bp</a:t>
            </a:r>
            <a:endParaRPr lang="en-BE" sz="9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39A1AE5-20FF-38CF-199A-69AB279168B4}"/>
              </a:ext>
            </a:extLst>
          </p:cNvPr>
          <p:cNvSpPr txBox="1"/>
          <p:nvPr/>
        </p:nvSpPr>
        <p:spPr>
          <a:xfrm>
            <a:off x="572839" y="3643457"/>
            <a:ext cx="608493" cy="232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500 bp</a:t>
            </a:r>
            <a:endParaRPr lang="en-BE" sz="9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438C5D6-29C1-CE7B-EA44-0B3B5179062C}"/>
              </a:ext>
            </a:extLst>
          </p:cNvPr>
          <p:cNvSpPr txBox="1"/>
          <p:nvPr/>
        </p:nvSpPr>
        <p:spPr>
          <a:xfrm>
            <a:off x="572839" y="3498019"/>
            <a:ext cx="608493" cy="232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650 bp</a:t>
            </a:r>
            <a:endParaRPr lang="en-BE" sz="9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C0E8D06-3AB4-8493-6CB5-AEA69786BC68}"/>
              </a:ext>
            </a:extLst>
          </p:cNvPr>
          <p:cNvSpPr txBox="1"/>
          <p:nvPr/>
        </p:nvSpPr>
        <p:spPr>
          <a:xfrm>
            <a:off x="572839" y="3346197"/>
            <a:ext cx="608493" cy="232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850 bp</a:t>
            </a:r>
            <a:endParaRPr lang="en-BE" sz="9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5ABF80F-8205-DD6C-F2A6-BA1D7BF39737}"/>
              </a:ext>
            </a:extLst>
          </p:cNvPr>
          <p:cNvSpPr txBox="1"/>
          <p:nvPr/>
        </p:nvSpPr>
        <p:spPr>
          <a:xfrm>
            <a:off x="501517" y="3248799"/>
            <a:ext cx="679815" cy="232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1000 bp</a:t>
            </a:r>
            <a:endParaRPr lang="en-BE" sz="9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6ADB253-1A7A-E531-55F3-01C6EB933244}"/>
              </a:ext>
            </a:extLst>
          </p:cNvPr>
          <p:cNvSpPr txBox="1"/>
          <p:nvPr/>
        </p:nvSpPr>
        <p:spPr>
          <a:xfrm>
            <a:off x="501517" y="3040711"/>
            <a:ext cx="679815" cy="232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/>
              <a:t>1500 bp</a:t>
            </a:r>
            <a:endParaRPr lang="en-BE" sz="900" dirty="0"/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D89BE18B-E4DC-5371-8B1B-882005376EEB}"/>
              </a:ext>
            </a:extLst>
          </p:cNvPr>
          <p:cNvCxnSpPr>
            <a:cxnSpLocks/>
          </p:cNvCxnSpPr>
          <p:nvPr/>
        </p:nvCxnSpPr>
        <p:spPr>
          <a:xfrm>
            <a:off x="1633633" y="1915856"/>
            <a:ext cx="4162884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C7BD8D35-B7E8-4DEA-A690-12DE2EE51B4E}"/>
              </a:ext>
            </a:extLst>
          </p:cNvPr>
          <p:cNvSpPr txBox="1"/>
          <p:nvPr/>
        </p:nvSpPr>
        <p:spPr>
          <a:xfrm>
            <a:off x="2508705" y="1488290"/>
            <a:ext cx="26287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DNA (individual insect #)</a:t>
            </a:r>
            <a:endParaRPr lang="en-BE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6FDD7EF-7520-BF47-666F-E5C35D272F19}"/>
              </a:ext>
            </a:extLst>
          </p:cNvPr>
          <p:cNvSpPr txBox="1"/>
          <p:nvPr/>
        </p:nvSpPr>
        <p:spPr>
          <a:xfrm>
            <a:off x="1633633" y="19158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1</a:t>
            </a:r>
            <a:endParaRPr lang="en-BE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72AC10C-A193-38F3-F50F-6924286EA98A}"/>
              </a:ext>
            </a:extLst>
          </p:cNvPr>
          <p:cNvSpPr txBox="1"/>
          <p:nvPr/>
        </p:nvSpPr>
        <p:spPr>
          <a:xfrm>
            <a:off x="2056630" y="19158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2</a:t>
            </a:r>
            <a:endParaRPr lang="en-BE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957E034-F786-C350-2014-421DBFD1B2F8}"/>
              </a:ext>
            </a:extLst>
          </p:cNvPr>
          <p:cNvSpPr txBox="1"/>
          <p:nvPr/>
        </p:nvSpPr>
        <p:spPr>
          <a:xfrm>
            <a:off x="2542751" y="19158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3</a:t>
            </a:r>
            <a:endParaRPr lang="en-BE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D317779-4B36-B86D-1908-6410E1DD6F3E}"/>
              </a:ext>
            </a:extLst>
          </p:cNvPr>
          <p:cNvSpPr txBox="1"/>
          <p:nvPr/>
        </p:nvSpPr>
        <p:spPr>
          <a:xfrm>
            <a:off x="3015343" y="19158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4</a:t>
            </a:r>
            <a:endParaRPr lang="en-BE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0C67198-20B4-501E-7492-A688178BAE98}"/>
              </a:ext>
            </a:extLst>
          </p:cNvPr>
          <p:cNvSpPr txBox="1"/>
          <p:nvPr/>
        </p:nvSpPr>
        <p:spPr>
          <a:xfrm>
            <a:off x="3514993" y="19158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5</a:t>
            </a:r>
            <a:endParaRPr lang="en-BE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9CD9FE4-B3FA-C486-93F2-D320561B3454}"/>
              </a:ext>
            </a:extLst>
          </p:cNvPr>
          <p:cNvSpPr txBox="1"/>
          <p:nvPr/>
        </p:nvSpPr>
        <p:spPr>
          <a:xfrm>
            <a:off x="3970661" y="19158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6</a:t>
            </a:r>
            <a:endParaRPr lang="en-BE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1551048-2642-5C10-1A65-6066E1231367}"/>
              </a:ext>
            </a:extLst>
          </p:cNvPr>
          <p:cNvSpPr txBox="1"/>
          <p:nvPr/>
        </p:nvSpPr>
        <p:spPr>
          <a:xfrm>
            <a:off x="4439832" y="19158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7</a:t>
            </a:r>
            <a:endParaRPr lang="en-BE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A076084-13D1-B30C-0312-D9F429DEF5A2}"/>
              </a:ext>
            </a:extLst>
          </p:cNvPr>
          <p:cNvSpPr txBox="1"/>
          <p:nvPr/>
        </p:nvSpPr>
        <p:spPr>
          <a:xfrm>
            <a:off x="4950683" y="19158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8</a:t>
            </a:r>
            <a:endParaRPr lang="en-BE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E7E6572-9199-6AEC-4436-03BD13FDB34A}"/>
              </a:ext>
            </a:extLst>
          </p:cNvPr>
          <p:cNvSpPr txBox="1"/>
          <p:nvPr/>
        </p:nvSpPr>
        <p:spPr>
          <a:xfrm>
            <a:off x="5436208" y="1915856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9</a:t>
            </a:r>
            <a:endParaRPr lang="en-BE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8625540-4099-9CF1-EFBE-42BFF78B2133}"/>
              </a:ext>
            </a:extLst>
          </p:cNvPr>
          <p:cNvSpPr txBox="1"/>
          <p:nvPr/>
        </p:nvSpPr>
        <p:spPr>
          <a:xfrm>
            <a:off x="5935858" y="1915856"/>
            <a:ext cx="2632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-</a:t>
            </a:r>
            <a:endParaRPr lang="en-BE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5AF8281-E148-6ED9-96D6-9A674CBAED4E}"/>
              </a:ext>
            </a:extLst>
          </p:cNvPr>
          <p:cNvSpPr txBox="1"/>
          <p:nvPr/>
        </p:nvSpPr>
        <p:spPr>
          <a:xfrm>
            <a:off x="7005292" y="2716010"/>
            <a:ext cx="4685191" cy="18603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800" b="1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Figure S6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: Amplicons produced by PCR with </a:t>
            </a:r>
            <a:r>
              <a:rPr lang="en-US" sz="1800" i="1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E. variegatus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actin-specific primers from DNA of </a:t>
            </a:r>
            <a:r>
              <a:rPr lang="en-US" sz="1800" i="1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E. variegatus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individuals persistently infected with EVV1. The </a:t>
            </a:r>
            <a:r>
              <a:rPr lang="en-US" sz="1800" dirty="0" err="1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Thermo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Fisher Scientific 1 </a:t>
            </a:r>
            <a:r>
              <a:rPr lang="en-US" sz="1800" dirty="0" err="1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Kb</a:t>
            </a:r>
            <a:r>
              <a:rPr lang="en-US" sz="1800" dirty="0">
                <a:effectLst/>
                <a:latin typeface="Aptos" panose="020B00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Plus DNA ladder was used as a reference.</a:t>
            </a:r>
            <a:endParaRPr lang="en-BE" sz="1800" dirty="0">
              <a:effectLst/>
              <a:latin typeface="Aptos" panose="020B00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9086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091</Words>
  <Application>Microsoft Office PowerPoint</Application>
  <PresentationFormat>Widescreen</PresentationFormat>
  <Paragraphs>279</Paragraphs>
  <Slides>7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ton Bilsen</dc:creator>
  <cp:lastModifiedBy>Anton Bilsen</cp:lastModifiedBy>
  <cp:revision>3</cp:revision>
  <dcterms:created xsi:type="dcterms:W3CDTF">2026-03-29T18:58:41Z</dcterms:created>
  <dcterms:modified xsi:type="dcterms:W3CDTF">2026-03-30T08:00:25Z</dcterms:modified>
</cp:coreProperties>
</file>